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397" r:id="rId2"/>
    <p:sldId id="411" r:id="rId3"/>
    <p:sldId id="398" r:id="rId4"/>
    <p:sldId id="399" r:id="rId5"/>
    <p:sldId id="400" r:id="rId6"/>
    <p:sldId id="401" r:id="rId7"/>
  </p:sldIdLst>
  <p:sldSz cx="6858000" cy="9906000" type="A4"/>
  <p:notesSz cx="6858000" cy="9945688"/>
  <p:defaultTextStyle>
    <a:defPPr>
      <a:defRPr lang="zh-CN"/>
    </a:defPPr>
    <a:lvl1pPr marL="0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3375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66750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00125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33500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66875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00250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33625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667000" algn="l" defTabSz="66611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0">
          <p15:clr>
            <a:srgbClr val="A4A3A4"/>
          </p15:clr>
        </p15:guide>
        <p15:guide id="2" pos="2136" userDrawn="1">
          <p15:clr>
            <a:srgbClr val="A4A3A4"/>
          </p15:clr>
        </p15:guide>
        <p15:guide id="3" orient="horz" pos="164">
          <p15:clr>
            <a:srgbClr val="A4A3A4"/>
          </p15:clr>
        </p15:guide>
        <p15:guide id="4" pos="960" userDrawn="1">
          <p15:clr>
            <a:srgbClr val="A4A3A4"/>
          </p15:clr>
        </p15:guide>
        <p15:guide id="5" orient="horz" pos="3048" userDrawn="1">
          <p15:clr>
            <a:srgbClr val="A4A3A4"/>
          </p15:clr>
        </p15:guide>
        <p15:guide id="6" pos="1594">
          <p15:clr>
            <a:srgbClr val="A4A3A4"/>
          </p15:clr>
        </p15:guide>
        <p15:guide id="7" orient="horz" pos="172">
          <p15:clr>
            <a:srgbClr val="A4A3A4"/>
          </p15:clr>
        </p15:guide>
        <p15:guide id="8" orient="horz" pos="2496" userDrawn="1">
          <p15:clr>
            <a:srgbClr val="A4A3A4"/>
          </p15:clr>
        </p15:guide>
        <p15:guide id="9" orient="horz" pos="452">
          <p15:clr>
            <a:srgbClr val="A4A3A4"/>
          </p15:clr>
        </p15:guide>
        <p15:guide id="10" pos="3672" userDrawn="1">
          <p15:clr>
            <a:srgbClr val="A4A3A4"/>
          </p15:clr>
        </p15:guide>
        <p15:guide id="11" pos="2423">
          <p15:clr>
            <a:srgbClr val="A4A3A4"/>
          </p15:clr>
        </p15:guide>
        <p15:guide id="12" pos="1272">
          <p15:clr>
            <a:srgbClr val="A4A3A4"/>
          </p15:clr>
        </p15:guide>
        <p15:guide id="13" orient="horz" pos="2592" userDrawn="1">
          <p15:clr>
            <a:srgbClr val="A4A3A4"/>
          </p15:clr>
        </p15:guide>
        <p15:guide id="14" orient="horz" pos="6024" userDrawn="1">
          <p15:clr>
            <a:srgbClr val="A4A3A4"/>
          </p15:clr>
        </p15:guide>
        <p15:guide id="15" orient="horz" pos="2976" userDrawn="1">
          <p15:clr>
            <a:srgbClr val="A4A3A4"/>
          </p15:clr>
        </p15:guide>
        <p15:guide id="16" orient="horz" pos="552">
          <p15:clr>
            <a:srgbClr val="A4A3A4"/>
          </p15:clr>
        </p15:guide>
        <p15:guide id="17" pos="1584" userDrawn="1">
          <p15:clr>
            <a:srgbClr val="A4A3A4"/>
          </p15:clr>
        </p15:guide>
        <p15:guide id="19" pos="2275">
          <p15:clr>
            <a:srgbClr val="A4A3A4"/>
          </p15:clr>
        </p15:guide>
        <p15:guide id="20" pos="2232" userDrawn="1">
          <p15:clr>
            <a:srgbClr val="A4A3A4"/>
          </p15:clr>
        </p15:guide>
        <p15:guide id="21" orient="horz" pos="3600" userDrawn="1">
          <p15:clr>
            <a:srgbClr val="A4A3A4"/>
          </p15:clr>
        </p15:guide>
        <p15:guide id="22" orient="horz" pos="27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CCCCCC"/>
    <a:srgbClr val="66CCEE"/>
    <a:srgbClr val="228833"/>
    <a:srgbClr val="EE9944"/>
    <a:srgbClr val="BBBBBB"/>
    <a:srgbClr val="FFFFFF"/>
    <a:srgbClr val="0072B2"/>
    <a:srgbClr val="000080"/>
    <a:srgbClr val="663399"/>
    <a:srgbClr val="8B451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6D684A4-9440-43CD-9A10-3D81A5DDC5AE}" v="20" dt="2026-03-03T01:44:15.48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012ECD-51FC-41F1-AA8D-1B2483CD663E}" styleName="淡色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9631B5-78F2-41C9-869B-9F39066F8104}" styleName="中度样式 3 - 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20" autoAdjust="0"/>
    <p:restoredTop sz="97252" autoAdjust="0"/>
  </p:normalViewPr>
  <p:slideViewPr>
    <p:cSldViewPr snapToGrid="0">
      <p:cViewPr varScale="1">
        <p:scale>
          <a:sx n="106" d="100"/>
          <a:sy n="106" d="100"/>
        </p:scale>
        <p:origin x="1052" y="72"/>
      </p:cViewPr>
      <p:guideLst>
        <p:guide orient="horz" pos="130"/>
        <p:guide pos="2136"/>
        <p:guide orient="horz" pos="164"/>
        <p:guide pos="960"/>
        <p:guide orient="horz" pos="3048"/>
        <p:guide pos="1594"/>
        <p:guide orient="horz" pos="172"/>
        <p:guide orient="horz" pos="2496"/>
        <p:guide orient="horz" pos="452"/>
        <p:guide pos="3672"/>
        <p:guide pos="2423"/>
        <p:guide pos="1272"/>
        <p:guide orient="horz" pos="2592"/>
        <p:guide orient="horz" pos="6024"/>
        <p:guide orient="horz" pos="2976"/>
        <p:guide orient="horz" pos="552"/>
        <p:guide pos="1584"/>
        <p:guide pos="2275"/>
        <p:guide pos="2232"/>
        <p:guide orient="horz" pos="3600"/>
        <p:guide orient="horz" pos="27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nqing Wang" userId="095b59ed7c59d507" providerId="LiveId" clId="{1051F5D8-0249-4F66-B4EC-BC7F3FD39964}"/>
    <pc:docChg chg="undo redo custSel addSld delSld modSld sldOrd">
      <pc:chgData name="Wanqing Wang" userId="095b59ed7c59d507" providerId="LiveId" clId="{1051F5D8-0249-4F66-B4EC-BC7F3FD39964}" dt="2026-03-03T02:16:39.827" v="989" actId="47"/>
      <pc:docMkLst>
        <pc:docMk/>
      </pc:docMkLst>
      <pc:sldChg chg="addSp delSp modSp del mod">
        <pc:chgData name="Wanqing Wang" userId="095b59ed7c59d507" providerId="LiveId" clId="{1051F5D8-0249-4F66-B4EC-BC7F3FD39964}" dt="2026-03-03T02:16:39.827" v="989" actId="47"/>
        <pc:sldMkLst>
          <pc:docMk/>
          <pc:sldMk cId="2903909207" sldId="361"/>
        </pc:sldMkLst>
        <pc:grpChg chg="add mod">
          <ac:chgData name="Wanqing Wang" userId="095b59ed7c59d507" providerId="LiveId" clId="{1051F5D8-0249-4F66-B4EC-BC7F3FD39964}" dt="2026-03-03T01:41:34.799" v="926" actId="164"/>
          <ac:grpSpMkLst>
            <pc:docMk/>
            <pc:sldMk cId="2903909207" sldId="361"/>
            <ac:grpSpMk id="13" creationId="{1E253FCE-C267-9EC0-26C5-B6BF966381BC}"/>
          </ac:grpSpMkLst>
        </pc:grpChg>
        <pc:grpChg chg="add mod">
          <ac:chgData name="Wanqing Wang" userId="095b59ed7c59d507" providerId="LiveId" clId="{1051F5D8-0249-4F66-B4EC-BC7F3FD39964}" dt="2026-03-03T01:44:15.474" v="945" actId="164"/>
          <ac:grpSpMkLst>
            <pc:docMk/>
            <pc:sldMk cId="2903909207" sldId="361"/>
            <ac:grpSpMk id="19" creationId="{2AD5D9F6-362D-DD8C-622A-A162D3ACB205}"/>
          </ac:grpSpMkLst>
        </pc:grpChg>
        <pc:grpChg chg="del">
          <ac:chgData name="Wanqing Wang" userId="095b59ed7c59d507" providerId="LiveId" clId="{1051F5D8-0249-4F66-B4EC-BC7F3FD39964}" dt="2026-03-03T01:40:38.268" v="920" actId="478"/>
          <ac:grpSpMkLst>
            <pc:docMk/>
            <pc:sldMk cId="2903909207" sldId="361"/>
            <ac:grpSpMk id="39" creationId="{25542F73-B7B2-4931-498F-1F1F1334D7B2}"/>
          </ac:grpSpMkLst>
        </pc:grpChg>
        <pc:grpChg chg="mod">
          <ac:chgData name="Wanqing Wang" userId="095b59ed7c59d507" providerId="LiveId" clId="{1051F5D8-0249-4F66-B4EC-BC7F3FD39964}" dt="2026-03-03T01:41:34.799" v="926" actId="164"/>
          <ac:grpSpMkLst>
            <pc:docMk/>
            <pc:sldMk cId="2903909207" sldId="361"/>
            <ac:grpSpMk id="43" creationId="{7BC25C30-8F12-6A47-2668-38135AFF7A20}"/>
          </ac:grpSpMkLst>
        </pc:grpChg>
        <pc:grpChg chg="mod">
          <ac:chgData name="Wanqing Wang" userId="095b59ed7c59d507" providerId="LiveId" clId="{1051F5D8-0249-4F66-B4EC-BC7F3FD39964}" dt="2026-03-03T01:44:15.474" v="945" actId="164"/>
          <ac:grpSpMkLst>
            <pc:docMk/>
            <pc:sldMk cId="2903909207" sldId="361"/>
            <ac:grpSpMk id="46" creationId="{72785323-3DFB-AC87-30F6-3CD92B3636B7}"/>
          </ac:grpSpMkLst>
        </pc:grpChg>
        <pc:picChg chg="add mod ord modCrop">
          <ac:chgData name="Wanqing Wang" userId="095b59ed7c59d507" providerId="LiveId" clId="{1051F5D8-0249-4F66-B4EC-BC7F3FD39964}" dt="2026-03-03T01:41:34.799" v="926" actId="164"/>
          <ac:picMkLst>
            <pc:docMk/>
            <pc:sldMk cId="2903909207" sldId="361"/>
            <ac:picMk id="12" creationId="{EF8A411F-2093-75AE-D06B-9012FF717B74}"/>
          </ac:picMkLst>
        </pc:picChg>
        <pc:picChg chg="add mod ord modCrop">
          <ac:chgData name="Wanqing Wang" userId="095b59ed7c59d507" providerId="LiveId" clId="{1051F5D8-0249-4F66-B4EC-BC7F3FD39964}" dt="2026-03-03T01:44:15.474" v="945" actId="164"/>
          <ac:picMkLst>
            <pc:docMk/>
            <pc:sldMk cId="2903909207" sldId="361"/>
            <ac:picMk id="18" creationId="{5FEDDEAC-80CE-2D7C-D0CC-EE894BE4E6C7}"/>
          </ac:picMkLst>
        </pc:picChg>
        <pc:picChg chg="del">
          <ac:chgData name="Wanqing Wang" userId="095b59ed7c59d507" providerId="LiveId" clId="{1051F5D8-0249-4F66-B4EC-BC7F3FD39964}" dt="2026-03-03T01:40:38.268" v="920" actId="478"/>
          <ac:picMkLst>
            <pc:docMk/>
            <pc:sldMk cId="2903909207" sldId="361"/>
            <ac:picMk id="31" creationId="{09CADB14-E486-F1E7-C6F8-D07F6462E150}"/>
          </ac:picMkLst>
        </pc:picChg>
        <pc:picChg chg="del">
          <ac:chgData name="Wanqing Wang" userId="095b59ed7c59d507" providerId="LiveId" clId="{1051F5D8-0249-4F66-B4EC-BC7F3FD39964}" dt="2026-03-03T01:43:14.734" v="941" actId="478"/>
          <ac:picMkLst>
            <pc:docMk/>
            <pc:sldMk cId="2903909207" sldId="361"/>
            <ac:picMk id="44" creationId="{5A0339C8-CE40-A89B-2B55-CD4A08AE9DB6}"/>
          </ac:picMkLst>
        </pc:picChg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138708393" sldId="363"/>
        </pc:sldMkLst>
      </pc:sldChg>
      <pc:sldChg chg="modSp del mod">
        <pc:chgData name="Wanqing Wang" userId="095b59ed7c59d507" providerId="LiveId" clId="{1051F5D8-0249-4F66-B4EC-BC7F3FD39964}" dt="2026-03-03T02:16:39.827" v="989" actId="47"/>
        <pc:sldMkLst>
          <pc:docMk/>
          <pc:sldMk cId="1607770624" sldId="373"/>
        </pc:sldMkLst>
        <pc:spChg chg="mod">
          <ac:chgData name="Wanqing Wang" userId="095b59ed7c59d507" providerId="LiveId" clId="{1051F5D8-0249-4F66-B4EC-BC7F3FD39964}" dt="2026-03-02T04:26:53.338" v="708" actId="114"/>
          <ac:spMkLst>
            <pc:docMk/>
            <pc:sldMk cId="1607770624" sldId="373"/>
            <ac:spMk id="34" creationId="{16B473E4-9466-AEE8-9B89-14B9C6257B5C}"/>
          </ac:spMkLst>
        </pc:spChg>
        <pc:spChg chg="mod">
          <ac:chgData name="Wanqing Wang" userId="095b59ed7c59d507" providerId="LiveId" clId="{1051F5D8-0249-4F66-B4EC-BC7F3FD39964}" dt="2026-03-03T01:49:32.621" v="965" actId="1076"/>
          <ac:spMkLst>
            <pc:docMk/>
            <pc:sldMk cId="1607770624" sldId="373"/>
            <ac:spMk id="43" creationId="{39DAFDEA-C660-A7B9-A62B-B16FA9ED4D30}"/>
          </ac:spMkLst>
        </pc:spChg>
        <pc:spChg chg="mod">
          <ac:chgData name="Wanqing Wang" userId="095b59ed7c59d507" providerId="LiveId" clId="{1051F5D8-0249-4F66-B4EC-BC7F3FD39964}" dt="2026-03-03T01:48:21.148" v="952" actId="20577"/>
          <ac:spMkLst>
            <pc:docMk/>
            <pc:sldMk cId="1607770624" sldId="373"/>
            <ac:spMk id="46" creationId="{F04BD739-2669-F79E-9681-DFB9243D315D}"/>
          </ac:spMkLst>
        </pc:spChg>
        <pc:spChg chg="mod">
          <ac:chgData name="Wanqing Wang" userId="095b59ed7c59d507" providerId="LiveId" clId="{1051F5D8-0249-4F66-B4EC-BC7F3FD39964}" dt="2026-03-03T01:49:27.253" v="964" actId="1076"/>
          <ac:spMkLst>
            <pc:docMk/>
            <pc:sldMk cId="1607770624" sldId="373"/>
            <ac:spMk id="49" creationId="{E52BB611-68D7-C35F-7655-9F55860A69CB}"/>
          </ac:spMkLst>
        </pc:spChg>
        <pc:spChg chg="mod">
          <ac:chgData name="Wanqing Wang" userId="095b59ed7c59d507" providerId="LiveId" clId="{1051F5D8-0249-4F66-B4EC-BC7F3FD39964}" dt="2026-03-03T01:49:35.648" v="966" actId="1076"/>
          <ac:spMkLst>
            <pc:docMk/>
            <pc:sldMk cId="1607770624" sldId="373"/>
            <ac:spMk id="52" creationId="{C84F5D53-2223-8456-F932-3DAC50A49920}"/>
          </ac:spMkLst>
        </pc:spChg>
        <pc:spChg chg="mod">
          <ac:chgData name="Wanqing Wang" userId="095b59ed7c59d507" providerId="LiveId" clId="{1051F5D8-0249-4F66-B4EC-BC7F3FD39964}" dt="2026-03-03T01:49:02.605" v="960" actId="1076"/>
          <ac:spMkLst>
            <pc:docMk/>
            <pc:sldMk cId="1607770624" sldId="373"/>
            <ac:spMk id="53" creationId="{7C725A4A-6FFF-E822-76E9-358684A2EF23}"/>
          </ac:spMkLst>
        </pc:spChg>
        <pc:spChg chg="mod">
          <ac:chgData name="Wanqing Wang" userId="095b59ed7c59d507" providerId="LiveId" clId="{1051F5D8-0249-4F66-B4EC-BC7F3FD39964}" dt="2026-03-02T04:26:57.507" v="709" actId="114"/>
          <ac:spMkLst>
            <pc:docMk/>
            <pc:sldMk cId="1607770624" sldId="373"/>
            <ac:spMk id="63" creationId="{E0F3C894-FEBE-198E-F575-FEFA8C235C86}"/>
          </ac:spMkLst>
        </pc:spChg>
        <pc:spChg chg="mod">
          <ac:chgData name="Wanqing Wang" userId="095b59ed7c59d507" providerId="LiveId" clId="{1051F5D8-0249-4F66-B4EC-BC7F3FD39964}" dt="2026-03-03T01:50:13.777" v="988" actId="14100"/>
          <ac:spMkLst>
            <pc:docMk/>
            <pc:sldMk cId="1607770624" sldId="373"/>
            <ac:spMk id="69" creationId="{E3A4147E-8F23-BC99-E6BD-D850DE67C5DB}"/>
          </ac:spMkLst>
        </pc:spChg>
      </pc:sldChg>
      <pc:sldChg chg="addSp delSp modSp del mod">
        <pc:chgData name="Wanqing Wang" userId="095b59ed7c59d507" providerId="LiveId" clId="{1051F5D8-0249-4F66-B4EC-BC7F3FD39964}" dt="2026-03-03T02:16:39.827" v="989" actId="47"/>
        <pc:sldMkLst>
          <pc:docMk/>
          <pc:sldMk cId="3526486575" sldId="374"/>
        </pc:sldMkLst>
        <pc:picChg chg="add del mod">
          <ac:chgData name="Wanqing Wang" userId="095b59ed7c59d507" providerId="LiveId" clId="{1051F5D8-0249-4F66-B4EC-BC7F3FD39964}" dt="2026-03-02T07:43:41.700" v="861" actId="931"/>
          <ac:picMkLst>
            <pc:docMk/>
            <pc:sldMk cId="3526486575" sldId="374"/>
            <ac:picMk id="3" creationId="{86482A35-FE8B-62A0-350A-025C78C511F4}"/>
          </ac:picMkLst>
        </pc:picChg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1680010288" sldId="376"/>
        </pc:sldMkLst>
      </pc:sldChg>
      <pc:sldChg chg="modSp del mod">
        <pc:chgData name="Wanqing Wang" userId="095b59ed7c59d507" providerId="LiveId" clId="{1051F5D8-0249-4F66-B4EC-BC7F3FD39964}" dt="2026-03-03T02:16:39.827" v="989" actId="47"/>
        <pc:sldMkLst>
          <pc:docMk/>
          <pc:sldMk cId="3383846256" sldId="377"/>
        </pc:sldMkLst>
        <pc:spChg chg="mod">
          <ac:chgData name="Wanqing Wang" userId="095b59ed7c59d507" providerId="LiveId" clId="{1051F5D8-0249-4F66-B4EC-BC7F3FD39964}" dt="2026-03-02T04:26:23.695" v="706" actId="114"/>
          <ac:spMkLst>
            <pc:docMk/>
            <pc:sldMk cId="3383846256" sldId="377"/>
            <ac:spMk id="16" creationId="{EF23B1AD-0769-A113-B56C-B5D348024043}"/>
          </ac:spMkLst>
        </pc:spChg>
      </pc:sldChg>
      <pc:sldChg chg="addSp delSp modSp del mod">
        <pc:chgData name="Wanqing Wang" userId="095b59ed7c59d507" providerId="LiveId" clId="{1051F5D8-0249-4F66-B4EC-BC7F3FD39964}" dt="2026-03-03T02:16:39.827" v="989" actId="47"/>
        <pc:sldMkLst>
          <pc:docMk/>
          <pc:sldMk cId="2348310255" sldId="384"/>
        </pc:sldMkLst>
        <pc:grpChg chg="add del mod">
          <ac:chgData name="Wanqing Wang" userId="095b59ed7c59d507" providerId="LiveId" clId="{1051F5D8-0249-4F66-B4EC-BC7F3FD39964}" dt="2026-03-02T07:45:09.864" v="875" actId="478"/>
          <ac:grpSpMkLst>
            <pc:docMk/>
            <pc:sldMk cId="2348310255" sldId="384"/>
            <ac:grpSpMk id="13" creationId="{A6345615-F171-FE2A-A0A9-52DDC9459417}"/>
          </ac:grpSpMkLst>
        </pc:grpChg>
        <pc:grpChg chg="add mod">
          <ac:chgData name="Wanqing Wang" userId="095b59ed7c59d507" providerId="LiveId" clId="{1051F5D8-0249-4F66-B4EC-BC7F3FD39964}" dt="2026-03-02T07:45:23.210" v="879" actId="164"/>
          <ac:grpSpMkLst>
            <pc:docMk/>
            <pc:sldMk cId="2348310255" sldId="384"/>
            <ac:grpSpMk id="26" creationId="{627AAE38-F11D-8700-B8EB-0C235BDEF595}"/>
          </ac:grpSpMkLst>
        </pc:grpChg>
        <pc:grpChg chg="add mod">
          <ac:chgData name="Wanqing Wang" userId="095b59ed7c59d507" providerId="LiveId" clId="{1051F5D8-0249-4F66-B4EC-BC7F3FD39964}" dt="2026-03-02T07:47:38.843" v="903" actId="164"/>
          <ac:grpSpMkLst>
            <pc:docMk/>
            <pc:sldMk cId="2348310255" sldId="384"/>
            <ac:grpSpMk id="32" creationId="{F6EBA273-55A1-1092-F556-877EFB22146C}"/>
          </ac:grpSpMkLst>
        </pc:grpChg>
        <pc:grpChg chg="mod topLvl">
          <ac:chgData name="Wanqing Wang" userId="095b59ed7c59d507" providerId="LiveId" clId="{1051F5D8-0249-4F66-B4EC-BC7F3FD39964}" dt="2026-03-02T07:45:23.210" v="879" actId="164"/>
          <ac:grpSpMkLst>
            <pc:docMk/>
            <pc:sldMk cId="2348310255" sldId="384"/>
            <ac:grpSpMk id="40" creationId="{5D5132EB-EECC-06E3-C6E5-8148051585B2}"/>
          </ac:grpSpMkLst>
        </pc:grpChg>
        <pc:grpChg chg="mod">
          <ac:chgData name="Wanqing Wang" userId="095b59ed7c59d507" providerId="LiveId" clId="{1051F5D8-0249-4F66-B4EC-BC7F3FD39964}" dt="2026-03-02T07:47:38.843" v="903" actId="164"/>
          <ac:grpSpMkLst>
            <pc:docMk/>
            <pc:sldMk cId="2348310255" sldId="384"/>
            <ac:grpSpMk id="46" creationId="{7DCCBFC4-FF20-5D78-F0AC-25574B04E6FE}"/>
          </ac:grpSpMkLst>
        </pc:grpChg>
        <pc:picChg chg="add del mod ord topLvl modCrop">
          <ac:chgData name="Wanqing Wang" userId="095b59ed7c59d507" providerId="LiveId" clId="{1051F5D8-0249-4F66-B4EC-BC7F3FD39964}" dt="2026-03-02T07:45:09.864" v="875" actId="478"/>
          <ac:picMkLst>
            <pc:docMk/>
            <pc:sldMk cId="2348310255" sldId="384"/>
            <ac:picMk id="8" creationId="{DAD9A286-EA0C-06A7-254D-34CDC46AE24D}"/>
          </ac:picMkLst>
        </pc:picChg>
        <pc:picChg chg="add mod ord modCrop">
          <ac:chgData name="Wanqing Wang" userId="095b59ed7c59d507" providerId="LiveId" clId="{1051F5D8-0249-4F66-B4EC-BC7F3FD39964}" dt="2026-03-02T07:45:23.210" v="879" actId="164"/>
          <ac:picMkLst>
            <pc:docMk/>
            <pc:sldMk cId="2348310255" sldId="384"/>
            <ac:picMk id="21" creationId="{36120C0B-1CBA-A22A-A487-702618190CA8}"/>
          </ac:picMkLst>
        </pc:picChg>
        <pc:picChg chg="add mod ord modCrop">
          <ac:chgData name="Wanqing Wang" userId="095b59ed7c59d507" providerId="LiveId" clId="{1051F5D8-0249-4F66-B4EC-BC7F3FD39964}" dt="2026-03-02T07:47:38.843" v="903" actId="164"/>
          <ac:picMkLst>
            <pc:docMk/>
            <pc:sldMk cId="2348310255" sldId="384"/>
            <ac:picMk id="31" creationId="{2A2E3800-E5A2-7E90-7BD0-E040ADFE3703}"/>
          </ac:picMkLst>
        </pc:picChg>
        <pc:picChg chg="del">
          <ac:chgData name="Wanqing Wang" userId="095b59ed7c59d507" providerId="LiveId" clId="{1051F5D8-0249-4F66-B4EC-BC7F3FD39964}" dt="2026-03-02T07:40:00.541" v="853" actId="478"/>
          <ac:picMkLst>
            <pc:docMk/>
            <pc:sldMk cId="2348310255" sldId="384"/>
            <ac:picMk id="50" creationId="{0E936550-2F6D-CC3C-85A7-4FE54D8684E6}"/>
          </ac:picMkLst>
        </pc:picChg>
        <pc:picChg chg="del">
          <ac:chgData name="Wanqing Wang" userId="095b59ed7c59d507" providerId="LiveId" clId="{1051F5D8-0249-4F66-B4EC-BC7F3FD39964}" dt="2026-03-02T07:46:53.002" v="897" actId="478"/>
          <ac:picMkLst>
            <pc:docMk/>
            <pc:sldMk cId="2348310255" sldId="384"/>
            <ac:picMk id="52" creationId="{B7901400-52C5-7F07-EB2B-5EE507FA6927}"/>
          </ac:picMkLst>
        </pc:picChg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4194275475" sldId="388"/>
        </pc:sldMkLst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570548690" sldId="389"/>
        </pc:sldMkLst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661507706" sldId="390"/>
        </pc:sldMkLst>
      </pc:sldChg>
      <pc:sldChg chg="modSp del mod">
        <pc:chgData name="Wanqing Wang" userId="095b59ed7c59d507" providerId="LiveId" clId="{1051F5D8-0249-4F66-B4EC-BC7F3FD39964}" dt="2026-03-03T02:16:39.827" v="989" actId="47"/>
        <pc:sldMkLst>
          <pc:docMk/>
          <pc:sldMk cId="1822442722" sldId="393"/>
        </pc:sldMkLst>
        <pc:spChg chg="mod">
          <ac:chgData name="Wanqing Wang" userId="095b59ed7c59d507" providerId="LiveId" clId="{1051F5D8-0249-4F66-B4EC-BC7F3FD39964}" dt="2026-03-02T04:26:44.988" v="707" actId="114"/>
          <ac:spMkLst>
            <pc:docMk/>
            <pc:sldMk cId="1822442722" sldId="393"/>
            <ac:spMk id="23" creationId="{E995B438-591B-DCCD-875D-15FDC35E4656}"/>
          </ac:spMkLst>
        </pc:spChg>
      </pc:sldChg>
      <pc:sldChg chg="add">
        <pc:chgData name="Wanqing Wang" userId="095b59ed7c59d507" providerId="LiveId" clId="{1051F5D8-0249-4F66-B4EC-BC7F3FD39964}" dt="2026-02-02T07:18:01.041" v="670"/>
        <pc:sldMkLst>
          <pc:docMk/>
          <pc:sldMk cId="4072535824" sldId="397"/>
        </pc:sldMkLst>
      </pc:sldChg>
      <pc:sldChg chg="modSp mod">
        <pc:chgData name="Wanqing Wang" userId="095b59ed7c59d507" providerId="LiveId" clId="{1051F5D8-0249-4F66-B4EC-BC7F3FD39964}" dt="2026-03-02T05:49:44.583" v="812" actId="113"/>
        <pc:sldMkLst>
          <pc:docMk/>
          <pc:sldMk cId="648432730" sldId="398"/>
        </pc:sldMkLst>
        <pc:spChg chg="mod">
          <ac:chgData name="Wanqing Wang" userId="095b59ed7c59d507" providerId="LiveId" clId="{1051F5D8-0249-4F66-B4EC-BC7F3FD39964}" dt="2026-02-02T07:18:08.472" v="674" actId="20577"/>
          <ac:spMkLst>
            <pc:docMk/>
            <pc:sldMk cId="648432730" sldId="398"/>
            <ac:spMk id="2" creationId="{8CC85F62-CBA0-7F4F-DF7F-AEFAE11950BC}"/>
          </ac:spMkLst>
        </pc:spChg>
        <pc:spChg chg="mod">
          <ac:chgData name="Wanqing Wang" userId="095b59ed7c59d507" providerId="LiveId" clId="{1051F5D8-0249-4F66-B4EC-BC7F3FD39964}" dt="2026-03-02T05:49:43.272" v="811" actId="113"/>
          <ac:spMkLst>
            <pc:docMk/>
            <pc:sldMk cId="648432730" sldId="398"/>
            <ac:spMk id="8" creationId="{680F9706-5528-BAF8-8BB2-478A324278E0}"/>
          </ac:spMkLst>
        </pc:spChg>
        <pc:spChg chg="mod">
          <ac:chgData name="Wanqing Wang" userId="095b59ed7c59d507" providerId="LiveId" clId="{1051F5D8-0249-4F66-B4EC-BC7F3FD39964}" dt="2026-03-02T05:49:44.583" v="812" actId="113"/>
          <ac:spMkLst>
            <pc:docMk/>
            <pc:sldMk cId="648432730" sldId="398"/>
            <ac:spMk id="9" creationId="{5EC8A69B-C849-1060-C2FC-C84608E921B3}"/>
          </ac:spMkLst>
        </pc:spChg>
        <pc:spChg chg="mod">
          <ac:chgData name="Wanqing Wang" userId="095b59ed7c59d507" providerId="LiveId" clId="{1051F5D8-0249-4F66-B4EC-BC7F3FD39964}" dt="2026-03-02T05:49:39.853" v="809" actId="113"/>
          <ac:spMkLst>
            <pc:docMk/>
            <pc:sldMk cId="648432730" sldId="398"/>
            <ac:spMk id="25" creationId="{644F81FC-451D-9923-62C2-002EB060759F}"/>
          </ac:spMkLst>
        </pc:spChg>
        <pc:spChg chg="mod">
          <ac:chgData name="Wanqing Wang" userId="095b59ed7c59d507" providerId="LiveId" clId="{1051F5D8-0249-4F66-B4EC-BC7F3FD39964}" dt="2026-03-02T05:49:41.570" v="810" actId="113"/>
          <ac:spMkLst>
            <pc:docMk/>
            <pc:sldMk cId="648432730" sldId="398"/>
            <ac:spMk id="26" creationId="{F5DD7C94-0D6B-7784-FF83-9B4A9A6D93F3}"/>
          </ac:spMkLst>
        </pc:spChg>
      </pc:sldChg>
      <pc:sldChg chg="modSp mod">
        <pc:chgData name="Wanqing Wang" userId="095b59ed7c59d507" providerId="LiveId" clId="{1051F5D8-0249-4F66-B4EC-BC7F3FD39964}" dt="2026-03-02T04:38:03.003" v="799" actId="114"/>
        <pc:sldMkLst>
          <pc:docMk/>
          <pc:sldMk cId="2828340097" sldId="399"/>
        </pc:sldMkLst>
        <pc:spChg chg="mod">
          <ac:chgData name="Wanqing Wang" userId="095b59ed7c59d507" providerId="LiveId" clId="{1051F5D8-0249-4F66-B4EC-BC7F3FD39964}" dt="2026-03-02T04:38:03.003" v="799" actId="114"/>
          <ac:spMkLst>
            <pc:docMk/>
            <pc:sldMk cId="2828340097" sldId="399"/>
            <ac:spMk id="14" creationId="{951789EE-AB84-0763-26F3-576CEF0DC1E7}"/>
          </ac:spMkLst>
        </pc:spChg>
      </pc:sldChg>
      <pc:sldChg chg="modSp mod">
        <pc:chgData name="Wanqing Wang" userId="095b59ed7c59d507" providerId="LiveId" clId="{1051F5D8-0249-4F66-B4EC-BC7F3FD39964}" dt="2026-03-02T04:38:14.335" v="801" actId="114"/>
        <pc:sldMkLst>
          <pc:docMk/>
          <pc:sldMk cId="3936043832" sldId="400"/>
        </pc:sldMkLst>
        <pc:spChg chg="mod">
          <ac:chgData name="Wanqing Wang" userId="095b59ed7c59d507" providerId="LiveId" clId="{1051F5D8-0249-4F66-B4EC-BC7F3FD39964}" dt="2026-03-02T04:38:14.335" v="801" actId="114"/>
          <ac:spMkLst>
            <pc:docMk/>
            <pc:sldMk cId="3936043832" sldId="400"/>
            <ac:spMk id="6" creationId="{11DA9093-6F28-831F-4A07-BB6D8F0C81FD}"/>
          </ac:spMkLst>
        </pc:spChg>
      </pc:sldChg>
      <pc:sldChg chg="modSp mod">
        <pc:chgData name="Wanqing Wang" userId="095b59ed7c59d507" providerId="LiveId" clId="{1051F5D8-0249-4F66-B4EC-BC7F3FD39964}" dt="2026-03-02T04:38:32.982" v="804" actId="114"/>
        <pc:sldMkLst>
          <pc:docMk/>
          <pc:sldMk cId="1241002752" sldId="401"/>
        </pc:sldMkLst>
        <pc:spChg chg="mod">
          <ac:chgData name="Wanqing Wang" userId="095b59ed7c59d507" providerId="LiveId" clId="{1051F5D8-0249-4F66-B4EC-BC7F3FD39964}" dt="2026-03-02T04:38:32.982" v="804" actId="114"/>
          <ac:spMkLst>
            <pc:docMk/>
            <pc:sldMk cId="1241002752" sldId="401"/>
            <ac:spMk id="14" creationId="{D1D9F4BA-28F3-A121-3A1D-1F79889E04C5}"/>
          </ac:spMkLst>
        </pc:spChg>
        <pc:picChg chg="mod">
          <ac:chgData name="Wanqing Wang" userId="095b59ed7c59d507" providerId="LiveId" clId="{1051F5D8-0249-4F66-B4EC-BC7F3FD39964}" dt="2026-02-02T07:18:21.198" v="682" actId="1076"/>
          <ac:picMkLst>
            <pc:docMk/>
            <pc:sldMk cId="1241002752" sldId="401"/>
            <ac:picMk id="13" creationId="{CB37DB46-FA58-24BA-9216-3FCFE0CE92A8}"/>
          </ac:picMkLst>
        </pc:picChg>
      </pc:sldChg>
      <pc:sldChg chg="addSp delSp modSp del mod">
        <pc:chgData name="Wanqing Wang" userId="095b59ed7c59d507" providerId="LiveId" clId="{1051F5D8-0249-4F66-B4EC-BC7F3FD39964}" dt="2026-03-03T02:16:39.827" v="989" actId="47"/>
        <pc:sldMkLst>
          <pc:docMk/>
          <pc:sldMk cId="3524176709" sldId="402"/>
        </pc:sldMkLst>
        <pc:spChg chg="mod">
          <ac:chgData name="Wanqing Wang" userId="095b59ed7c59d507" providerId="LiveId" clId="{1051F5D8-0249-4F66-B4EC-BC7F3FD39964}" dt="2026-03-02T04:26:15.239" v="705" actId="114"/>
          <ac:spMkLst>
            <pc:docMk/>
            <pc:sldMk cId="3524176709" sldId="402"/>
            <ac:spMk id="2" creationId="{58067630-56FB-4238-2548-9FCA21788583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23" creationId="{1CB91458-CB51-631E-D64D-1BDAAC1AE746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28" creationId="{159C994C-33AB-3576-BB6A-0E5EECD98777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29" creationId="{AE00A8FE-DE19-46B2-C5BB-5EE5815712F2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46" creationId="{415EF739-851B-3753-6693-A742176892D8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49" creationId="{78D78BEC-DF9C-7A95-1D63-6CAE1EC2D8F1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50" creationId="{CD63C0DA-1E1E-C803-1EDF-CA32507CCF01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52" creationId="{C0E41A1A-D024-F359-4D00-DF290B753C0C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53" creationId="{3A4EF89B-2574-8AC7-2210-BD65B6F33C10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55" creationId="{8544D9D4-BEF7-39F9-5213-8AD2EF92A5C7}"/>
          </ac:spMkLst>
        </pc:spChg>
        <pc:spChg chg="mod">
          <ac:chgData name="Wanqing Wang" userId="095b59ed7c59d507" providerId="LiveId" clId="{1051F5D8-0249-4F66-B4EC-BC7F3FD39964}" dt="2026-03-02T06:09:18.573" v="822" actId="14826"/>
          <ac:spMkLst>
            <pc:docMk/>
            <pc:sldMk cId="3524176709" sldId="402"/>
            <ac:spMk id="57" creationId="{C8926AF7-42C8-B010-FAB8-BBD07A187312}"/>
          </ac:spMkLst>
        </pc:spChg>
        <pc:grpChg chg="add mod">
          <ac:chgData name="Wanqing Wang" userId="095b59ed7c59d507" providerId="LiveId" clId="{1051F5D8-0249-4F66-B4EC-BC7F3FD39964}" dt="2026-03-02T06:11:06.533" v="835" actId="164"/>
          <ac:grpSpMkLst>
            <pc:docMk/>
            <pc:sldMk cId="3524176709" sldId="402"/>
            <ac:grpSpMk id="5" creationId="{833DEA31-30D5-1029-E60D-0DA8C7C3B5BE}"/>
          </ac:grpSpMkLst>
        </pc:grpChg>
        <pc:grpChg chg="del">
          <ac:chgData name="Wanqing Wang" userId="095b59ed7c59d507" providerId="LiveId" clId="{1051F5D8-0249-4F66-B4EC-BC7F3FD39964}" dt="2026-03-02T06:09:23.866" v="823" actId="478"/>
          <ac:grpSpMkLst>
            <pc:docMk/>
            <pc:sldMk cId="3524176709" sldId="402"/>
            <ac:grpSpMk id="14" creationId="{C4643D65-9FCC-4E75-9707-EFDDDABFD019}"/>
          </ac:grpSpMkLst>
        </pc:grpChg>
        <pc:grpChg chg="mod">
          <ac:chgData name="Wanqing Wang" userId="095b59ed7c59d507" providerId="LiveId" clId="{1051F5D8-0249-4F66-B4EC-BC7F3FD39964}" dt="2026-03-02T06:11:06.533" v="835" actId="164"/>
          <ac:grpSpMkLst>
            <pc:docMk/>
            <pc:sldMk cId="3524176709" sldId="402"/>
            <ac:grpSpMk id="71" creationId="{1E58FA76-C566-C042-8F79-B6A167C8CDA9}"/>
          </ac:grpSpMkLst>
        </pc:grpChg>
        <pc:picChg chg="add mod ord modCrop">
          <ac:chgData name="Wanqing Wang" userId="095b59ed7c59d507" providerId="LiveId" clId="{1051F5D8-0249-4F66-B4EC-BC7F3FD39964}" dt="2026-03-02T06:11:06.533" v="835" actId="164"/>
          <ac:picMkLst>
            <pc:docMk/>
            <pc:sldMk cId="3524176709" sldId="402"/>
            <ac:picMk id="4" creationId="{398FF430-F39B-ECCA-C5FB-63C3F530A204}"/>
          </ac:picMkLst>
        </pc:picChg>
        <pc:picChg chg="del">
          <ac:chgData name="Wanqing Wang" userId="095b59ed7c59d507" providerId="LiveId" clId="{1051F5D8-0249-4F66-B4EC-BC7F3FD39964}" dt="2026-03-02T06:09:23.866" v="823" actId="478"/>
          <ac:picMkLst>
            <pc:docMk/>
            <pc:sldMk cId="3524176709" sldId="402"/>
            <ac:picMk id="12" creationId="{0B754988-9C36-5897-8845-A95737B3EFA4}"/>
          </ac:picMkLst>
        </pc:picChg>
      </pc:sldChg>
      <pc:sldChg chg="del">
        <pc:chgData name="Wanqing Wang" userId="095b59ed7c59d507" providerId="LiveId" clId="{1051F5D8-0249-4F66-B4EC-BC7F3FD39964}" dt="2026-03-03T02:16:39.827" v="989" actId="47"/>
        <pc:sldMkLst>
          <pc:docMk/>
          <pc:sldMk cId="210241170" sldId="403"/>
        </pc:sldMkLst>
      </pc:sldChg>
      <pc:sldChg chg="addSp modSp del mod">
        <pc:chgData name="Wanqing Wang" userId="095b59ed7c59d507" providerId="LiveId" clId="{1051F5D8-0249-4F66-B4EC-BC7F3FD39964}" dt="2026-03-03T02:16:39.827" v="989" actId="47"/>
        <pc:sldMkLst>
          <pc:docMk/>
          <pc:sldMk cId="2782701053" sldId="404"/>
        </pc:sldMkLst>
      </pc:sldChg>
      <pc:sldChg chg="addSp modSp del mod">
        <pc:chgData name="Wanqing Wang" userId="095b59ed7c59d507" providerId="LiveId" clId="{1051F5D8-0249-4F66-B4EC-BC7F3FD39964}" dt="2026-03-03T02:16:39.827" v="989" actId="47"/>
        <pc:sldMkLst>
          <pc:docMk/>
          <pc:sldMk cId="2817875567" sldId="405"/>
        </pc:sldMkLst>
        <pc:spChg chg="add mod">
          <ac:chgData name="Wanqing Wang" userId="095b59ed7c59d507" providerId="LiveId" clId="{1051F5D8-0249-4F66-B4EC-BC7F3FD39964}" dt="2026-03-02T04:35:12.094" v="791" actId="1076"/>
          <ac:spMkLst>
            <pc:docMk/>
            <pc:sldMk cId="2817875567" sldId="405"/>
            <ac:spMk id="7" creationId="{2CF97F67-69E8-1E96-CDA9-0B9606407F88}"/>
          </ac:spMkLst>
        </pc:spChg>
        <pc:spChg chg="add mod">
          <ac:chgData name="Wanqing Wang" userId="095b59ed7c59d507" providerId="LiveId" clId="{1051F5D8-0249-4F66-B4EC-BC7F3FD39964}" dt="2026-03-02T04:34:53.838" v="789" actId="164"/>
          <ac:spMkLst>
            <pc:docMk/>
            <pc:sldMk cId="2817875567" sldId="405"/>
            <ac:spMk id="9" creationId="{8FA9F012-DE79-6843-1CAA-A52083AF68CA}"/>
          </ac:spMkLst>
        </pc:spChg>
        <pc:grpChg chg="add mod">
          <ac:chgData name="Wanqing Wang" userId="095b59ed7c59d507" providerId="LiveId" clId="{1051F5D8-0249-4F66-B4EC-BC7F3FD39964}" dt="2026-03-02T04:30:57.194" v="747" actId="164"/>
          <ac:grpSpMkLst>
            <pc:docMk/>
            <pc:sldMk cId="2817875567" sldId="405"/>
            <ac:grpSpMk id="8" creationId="{23530CC5-3AA5-FC10-DBBD-A8147CE9C49C}"/>
          </ac:grpSpMkLst>
        </pc:grpChg>
        <pc:grpChg chg="mod">
          <ac:chgData name="Wanqing Wang" userId="095b59ed7c59d507" providerId="LiveId" clId="{1051F5D8-0249-4F66-B4EC-BC7F3FD39964}" dt="2026-03-02T04:34:53.838" v="789" actId="164"/>
          <ac:grpSpMkLst>
            <pc:docMk/>
            <pc:sldMk cId="2817875567" sldId="405"/>
            <ac:grpSpMk id="12" creationId="{517F7AB3-C2FE-14D7-41CB-59796E2C43D9}"/>
          </ac:grpSpMkLst>
        </pc:grpChg>
        <pc:grpChg chg="add mod">
          <ac:chgData name="Wanqing Wang" userId="095b59ed7c59d507" providerId="LiveId" clId="{1051F5D8-0249-4F66-B4EC-BC7F3FD39964}" dt="2026-03-02T04:34:53.838" v="789" actId="164"/>
          <ac:grpSpMkLst>
            <pc:docMk/>
            <pc:sldMk cId="2817875567" sldId="405"/>
            <ac:grpSpMk id="13" creationId="{856A4C6B-6E0E-729B-0893-6B6A853334F6}"/>
          </ac:grpSpMkLst>
        </pc:grpChg>
        <pc:grpChg chg="mod">
          <ac:chgData name="Wanqing Wang" userId="095b59ed7c59d507" providerId="LiveId" clId="{1051F5D8-0249-4F66-B4EC-BC7F3FD39964}" dt="2026-03-02T04:30:57.194" v="747" actId="164"/>
          <ac:grpSpMkLst>
            <pc:docMk/>
            <pc:sldMk cId="2817875567" sldId="405"/>
            <ac:grpSpMk id="22" creationId="{1B2007DD-8997-0ED7-9933-15BC87F32FD9}"/>
          </ac:grpSpMkLst>
        </pc:grpChg>
      </pc:sldChg>
      <pc:sldChg chg="addSp modSp del mod">
        <pc:chgData name="Wanqing Wang" userId="095b59ed7c59d507" providerId="LiveId" clId="{1051F5D8-0249-4F66-B4EC-BC7F3FD39964}" dt="2026-03-03T02:16:39.827" v="989" actId="47"/>
        <pc:sldMkLst>
          <pc:docMk/>
          <pc:sldMk cId="161745336" sldId="406"/>
        </pc:sldMkLst>
        <pc:spChg chg="add mod">
          <ac:chgData name="Wanqing Wang" userId="095b59ed7c59d507" providerId="LiveId" clId="{1051F5D8-0249-4F66-B4EC-BC7F3FD39964}" dt="2026-03-02T04:35:21.720" v="793" actId="255"/>
          <ac:spMkLst>
            <pc:docMk/>
            <pc:sldMk cId="161745336" sldId="406"/>
            <ac:spMk id="6" creationId="{30B3A0A0-8182-77D7-4E0B-68B5BE8E1323}"/>
          </ac:spMkLst>
        </pc:spChg>
        <pc:spChg chg="add mod">
          <ac:chgData name="Wanqing Wang" userId="095b59ed7c59d507" providerId="LiveId" clId="{1051F5D8-0249-4F66-B4EC-BC7F3FD39964}" dt="2026-03-02T04:35:27.847" v="794" actId="255"/>
          <ac:spMkLst>
            <pc:docMk/>
            <pc:sldMk cId="161745336" sldId="406"/>
            <ac:spMk id="8" creationId="{ABFCE2E9-DF00-551B-3C1E-5668021103C3}"/>
          </ac:spMkLst>
        </pc:spChg>
        <pc:grpChg chg="add mod">
          <ac:chgData name="Wanqing Wang" userId="095b59ed7c59d507" providerId="LiveId" clId="{1051F5D8-0249-4F66-B4EC-BC7F3FD39964}" dt="2026-03-02T04:30:14.290" v="732" actId="164"/>
          <ac:grpSpMkLst>
            <pc:docMk/>
            <pc:sldMk cId="161745336" sldId="406"/>
            <ac:grpSpMk id="10" creationId="{446B3BA8-CCF2-68A3-9E74-42C43D2AD5FA}"/>
          </ac:grpSpMkLst>
        </pc:grpChg>
        <pc:grpChg chg="add mod">
          <ac:chgData name="Wanqing Wang" userId="095b59ed7c59d507" providerId="LiveId" clId="{1051F5D8-0249-4F66-B4EC-BC7F3FD39964}" dt="2026-03-02T04:30:34.764" v="737" actId="164"/>
          <ac:grpSpMkLst>
            <pc:docMk/>
            <pc:sldMk cId="161745336" sldId="406"/>
            <ac:grpSpMk id="12" creationId="{5E0F8688-EDFE-097C-005B-20EBC6DB84AE}"/>
          </ac:grpSpMkLst>
        </pc:grpChg>
        <pc:grpChg chg="mod">
          <ac:chgData name="Wanqing Wang" userId="095b59ed7c59d507" providerId="LiveId" clId="{1051F5D8-0249-4F66-B4EC-BC7F3FD39964}" dt="2026-03-02T04:30:34.764" v="737" actId="164"/>
          <ac:grpSpMkLst>
            <pc:docMk/>
            <pc:sldMk cId="161745336" sldId="406"/>
            <ac:grpSpMk id="23" creationId="{46DA7231-8A2F-5180-BB21-62767A99C83B}"/>
          </ac:grpSpMkLst>
        </pc:grpChg>
        <pc:grpChg chg="mod">
          <ac:chgData name="Wanqing Wang" userId="095b59ed7c59d507" providerId="LiveId" clId="{1051F5D8-0249-4F66-B4EC-BC7F3FD39964}" dt="2026-03-02T04:30:14.290" v="732" actId="164"/>
          <ac:grpSpMkLst>
            <pc:docMk/>
            <pc:sldMk cId="161745336" sldId="406"/>
            <ac:grpSpMk id="29" creationId="{206E01F1-3DB7-2384-9C3B-3A510F552AF8}"/>
          </ac:grpSpMkLst>
        </pc:grpChg>
      </pc:sldChg>
      <pc:sldChg chg="modSp mod">
        <pc:chgData name="Wanqing Wang" userId="095b59ed7c59d507" providerId="LiveId" clId="{1051F5D8-0249-4F66-B4EC-BC7F3FD39964}" dt="2026-03-02T05:49:10.442" v="808"/>
        <pc:sldMkLst>
          <pc:docMk/>
          <pc:sldMk cId="403828419" sldId="411"/>
        </pc:sldMkLst>
        <pc:spChg chg="mod">
          <ac:chgData name="Wanqing Wang" userId="095b59ed7c59d507" providerId="LiveId" clId="{1051F5D8-0249-4F66-B4EC-BC7F3FD39964}" dt="2026-03-02T05:49:10.442" v="808"/>
          <ac:spMkLst>
            <pc:docMk/>
            <pc:sldMk cId="403828419" sldId="411"/>
            <ac:spMk id="2" creationId="{A81AF1DA-2190-F4EB-4C29-4DF5CB887B3A}"/>
          </ac:spMkLst>
        </pc:spChg>
        <pc:spChg chg="mod">
          <ac:chgData name="Wanqing Wang" userId="095b59ed7c59d507" providerId="LiveId" clId="{1051F5D8-0249-4F66-B4EC-BC7F3FD39964}" dt="2026-03-02T04:36:23.726" v="797" actId="114"/>
          <ac:spMkLst>
            <pc:docMk/>
            <pc:sldMk cId="403828419" sldId="411"/>
            <ac:spMk id="41" creationId="{44856A36-7A46-E498-DA5D-EF5FD42D72FC}"/>
          </ac:spMkLst>
        </pc:spChg>
        <pc:spChg chg="mod">
          <ac:chgData name="Wanqing Wang" userId="095b59ed7c59d507" providerId="LiveId" clId="{1051F5D8-0249-4F66-B4EC-BC7F3FD39964}" dt="2026-03-02T04:36:27.334" v="798" actId="114"/>
          <ac:spMkLst>
            <pc:docMk/>
            <pc:sldMk cId="403828419" sldId="411"/>
            <ac:spMk id="54" creationId="{6425FF13-2E81-D353-3506-113F1E7158F6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579744-BA75-44CF-B538-6369CF185996}" type="datetimeFigureOut">
              <a:rPr lang="zh-CN" altLang="en-US" smtClean="0"/>
              <a:t>2026/3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1243013"/>
            <a:ext cx="23241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6362"/>
            <a:ext cx="5486400" cy="391611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90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90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B6C084-01D6-48DE-A71A-3FA12DBECEE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3658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33375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66750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1000125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33500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666875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2000250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333625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667000" algn="l" defTabSz="666115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or erf65: </a:t>
            </a:r>
            <a:r>
              <a:rPr lang="en-US" dirty="0" err="1"/>
              <a:t>cds</a:t>
            </a:r>
            <a:r>
              <a:rPr lang="en-US" dirty="0"/>
              <a:t> (MSU = RAP.1 &amp; .2)</a:t>
            </a:r>
          </a:p>
          <a:p>
            <a:r>
              <a:rPr lang="en-US" dirty="0"/>
              <a:t>Start ATG, end TGA</a:t>
            </a:r>
          </a:p>
          <a:p>
            <a:r>
              <a:rPr lang="en-US" dirty="0"/>
              <a:t>Target: AGAGGAAGACGCGATACCGA</a:t>
            </a:r>
            <a:r>
              <a:rPr lang="en-US" b="1" dirty="0"/>
              <a:t>GGG</a:t>
            </a:r>
          </a:p>
          <a:p>
            <a:endParaRPr lang="en-US" dirty="0"/>
          </a:p>
          <a:p>
            <a:r>
              <a:rPr lang="en-US" dirty="0"/>
              <a:t>For erf96.2: </a:t>
            </a:r>
            <a:r>
              <a:rPr lang="en-US" dirty="0" err="1"/>
              <a:t>cds</a:t>
            </a:r>
            <a:r>
              <a:rPr lang="en-US" dirty="0"/>
              <a:t> (MSU = RAP.1)</a:t>
            </a:r>
          </a:p>
          <a:p>
            <a:r>
              <a:rPr lang="en-US" dirty="0"/>
              <a:t>Start ATG, end TGA</a:t>
            </a:r>
          </a:p>
          <a:p>
            <a:r>
              <a:rPr lang="en-US" dirty="0"/>
              <a:t>Target: GAGTGCTTCGAGCTCGGCGG</a:t>
            </a:r>
            <a:r>
              <a:rPr lang="en-US" b="1" dirty="0"/>
              <a:t>CG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B6C084-01D6-48DE-A71A-3FA12DBECEEF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355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2"/>
            <a:ext cx="5829300" cy="3448755"/>
          </a:xfrm>
        </p:spPr>
        <p:txBody>
          <a:bodyPr anchor="b"/>
          <a:lstStyle>
            <a:lvl1pPr algn="ctr">
              <a:defRPr sz="5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2300"/>
            </a:lvl1pPr>
            <a:lvl2pPr marL="444500" indent="0" algn="ctr">
              <a:buNone/>
              <a:defRPr sz="1900"/>
            </a:lvl2pPr>
            <a:lvl3pPr marL="889000" indent="0" algn="ctr">
              <a:buNone/>
              <a:defRPr sz="1700"/>
            </a:lvl3pPr>
            <a:lvl4pPr marL="1333500" indent="0" algn="ctr">
              <a:buNone/>
              <a:defRPr sz="1600"/>
            </a:lvl4pPr>
            <a:lvl5pPr marL="1778000" indent="0" algn="ctr">
              <a:buNone/>
              <a:defRPr sz="1600"/>
            </a:lvl5pPr>
            <a:lvl6pPr marL="2222500" indent="0" algn="ctr">
              <a:buNone/>
              <a:defRPr sz="1600"/>
            </a:lvl6pPr>
            <a:lvl7pPr marL="2667000" indent="0" algn="ctr">
              <a:buNone/>
              <a:defRPr sz="1600"/>
            </a:lvl7pPr>
            <a:lvl8pPr marL="3110865" indent="0" algn="ctr">
              <a:buNone/>
              <a:defRPr sz="1600"/>
            </a:lvl8pPr>
            <a:lvl9pPr marL="3555365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5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8"/>
            <a:ext cx="5915025" cy="2166936"/>
          </a:xfrm>
        </p:spPr>
        <p:txBody>
          <a:bodyPr/>
          <a:lstStyle>
            <a:lvl1pPr marL="0" indent="0">
              <a:buNone/>
              <a:defRPr sz="2300">
                <a:solidFill>
                  <a:schemeClr val="tx1"/>
                </a:solidFill>
              </a:defRPr>
            </a:lvl1pPr>
            <a:lvl2pPr marL="44450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88900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3335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778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225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667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1108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5553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44500" indent="0">
              <a:buNone/>
              <a:defRPr sz="1900" b="1"/>
            </a:lvl2pPr>
            <a:lvl3pPr marL="889000" indent="0">
              <a:buNone/>
              <a:defRPr sz="1700" b="1"/>
            </a:lvl3pPr>
            <a:lvl4pPr marL="1333500" indent="0">
              <a:buNone/>
              <a:defRPr sz="1600" b="1"/>
            </a:lvl4pPr>
            <a:lvl5pPr marL="1778000" indent="0">
              <a:buNone/>
              <a:defRPr sz="1600" b="1"/>
            </a:lvl5pPr>
            <a:lvl6pPr marL="2222500" indent="0">
              <a:buNone/>
              <a:defRPr sz="1600" b="1"/>
            </a:lvl6pPr>
            <a:lvl7pPr marL="2667000" indent="0">
              <a:buNone/>
              <a:defRPr sz="1600" b="1"/>
            </a:lvl7pPr>
            <a:lvl8pPr marL="3110865" indent="0">
              <a:buNone/>
              <a:defRPr sz="1600" b="1"/>
            </a:lvl8pPr>
            <a:lvl9pPr marL="3555365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2300" b="1"/>
            </a:lvl1pPr>
            <a:lvl2pPr marL="444500" indent="0">
              <a:buNone/>
              <a:defRPr sz="1900" b="1"/>
            </a:lvl2pPr>
            <a:lvl3pPr marL="889000" indent="0">
              <a:buNone/>
              <a:defRPr sz="1700" b="1"/>
            </a:lvl3pPr>
            <a:lvl4pPr marL="1333500" indent="0">
              <a:buNone/>
              <a:defRPr sz="1600" b="1"/>
            </a:lvl4pPr>
            <a:lvl5pPr marL="1778000" indent="0">
              <a:buNone/>
              <a:defRPr sz="1600" b="1"/>
            </a:lvl5pPr>
            <a:lvl6pPr marL="2222500" indent="0">
              <a:buNone/>
              <a:defRPr sz="1600" b="1"/>
            </a:lvl6pPr>
            <a:lvl7pPr marL="2667000" indent="0">
              <a:buNone/>
              <a:defRPr sz="1600" b="1"/>
            </a:lvl7pPr>
            <a:lvl8pPr marL="3110865" indent="0">
              <a:buNone/>
              <a:defRPr sz="1600" b="1"/>
            </a:lvl8pPr>
            <a:lvl9pPr marL="3555365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3"/>
            <a:ext cx="2915543" cy="53221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3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3100"/>
            </a:lvl1pPr>
            <a:lvl2pPr>
              <a:defRPr sz="2700"/>
            </a:lvl2pPr>
            <a:lvl3pPr>
              <a:defRPr sz="23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3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44500" indent="0">
              <a:buNone/>
              <a:defRPr sz="1400"/>
            </a:lvl2pPr>
            <a:lvl3pPr marL="889000" indent="0">
              <a:buNone/>
              <a:defRPr sz="1200"/>
            </a:lvl3pPr>
            <a:lvl4pPr marL="1333500" indent="0">
              <a:buNone/>
              <a:defRPr sz="1000"/>
            </a:lvl4pPr>
            <a:lvl5pPr marL="1778000" indent="0">
              <a:buNone/>
              <a:defRPr sz="1000"/>
            </a:lvl5pPr>
            <a:lvl6pPr marL="2222500" indent="0">
              <a:buNone/>
              <a:defRPr sz="1000"/>
            </a:lvl6pPr>
            <a:lvl7pPr marL="2667000" indent="0">
              <a:buNone/>
              <a:defRPr sz="1000"/>
            </a:lvl7pPr>
            <a:lvl8pPr marL="3110865" indent="0">
              <a:buNone/>
              <a:defRPr sz="1000"/>
            </a:lvl8pPr>
            <a:lvl9pPr marL="3555365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3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3100"/>
            </a:lvl1pPr>
            <a:lvl2pPr marL="444500" indent="0">
              <a:buNone/>
              <a:defRPr sz="2700"/>
            </a:lvl2pPr>
            <a:lvl3pPr marL="889000" indent="0">
              <a:buNone/>
              <a:defRPr sz="2300"/>
            </a:lvl3pPr>
            <a:lvl4pPr marL="1333500" indent="0">
              <a:buNone/>
              <a:defRPr sz="1900"/>
            </a:lvl4pPr>
            <a:lvl5pPr marL="1778000" indent="0">
              <a:buNone/>
              <a:defRPr sz="1900"/>
            </a:lvl5pPr>
            <a:lvl6pPr marL="2222500" indent="0">
              <a:buNone/>
              <a:defRPr sz="1900"/>
            </a:lvl6pPr>
            <a:lvl7pPr marL="2667000" indent="0">
              <a:buNone/>
              <a:defRPr sz="1900"/>
            </a:lvl7pPr>
            <a:lvl8pPr marL="3110865" indent="0">
              <a:buNone/>
              <a:defRPr sz="1900"/>
            </a:lvl8pPr>
            <a:lvl9pPr marL="3555365" indent="0">
              <a:buNone/>
              <a:defRPr sz="19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3" cy="5505627"/>
          </a:xfrm>
        </p:spPr>
        <p:txBody>
          <a:bodyPr/>
          <a:lstStyle>
            <a:lvl1pPr marL="0" indent="0">
              <a:buNone/>
              <a:defRPr sz="1600"/>
            </a:lvl1pPr>
            <a:lvl2pPr marL="444500" indent="0">
              <a:buNone/>
              <a:defRPr sz="1400"/>
            </a:lvl2pPr>
            <a:lvl3pPr marL="889000" indent="0">
              <a:buNone/>
              <a:defRPr sz="1200"/>
            </a:lvl3pPr>
            <a:lvl4pPr marL="1333500" indent="0">
              <a:buNone/>
              <a:defRPr sz="1000"/>
            </a:lvl4pPr>
            <a:lvl5pPr marL="1778000" indent="0">
              <a:buNone/>
              <a:defRPr sz="1000"/>
            </a:lvl5pPr>
            <a:lvl6pPr marL="2222500" indent="0">
              <a:buNone/>
              <a:defRPr sz="1000"/>
            </a:lvl6pPr>
            <a:lvl7pPr marL="2667000" indent="0">
              <a:buNone/>
              <a:defRPr sz="1000"/>
            </a:lvl7pPr>
            <a:lvl8pPr marL="3110865" indent="0">
              <a:buNone/>
              <a:defRPr sz="1000"/>
            </a:lvl8pPr>
            <a:lvl9pPr marL="3555365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66669" tIns="33334" rIns="66669" bIns="33334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66669" tIns="33334" rIns="66669" bIns="33334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2"/>
          </a:xfrm>
          <a:prstGeom prst="rect">
            <a:avLst/>
          </a:prstGeom>
        </p:spPr>
        <p:txBody>
          <a:bodyPr vert="horz" lIns="66669" tIns="33334" rIns="66669" bIns="3333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26/3/3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2"/>
          </a:xfrm>
          <a:prstGeom prst="rect">
            <a:avLst/>
          </a:prstGeom>
        </p:spPr>
        <p:txBody>
          <a:bodyPr vert="horz" lIns="66669" tIns="33334" rIns="66669" bIns="3333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66669" tIns="33334" rIns="66669" bIns="3333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88365" rtl="0" eaLnBrk="1" latinLnBrk="0" hangingPunct="1">
        <a:lnSpc>
          <a:spcPct val="90000"/>
        </a:lnSpc>
        <a:spcBef>
          <a:spcPct val="0"/>
        </a:spcBef>
        <a:buNone/>
        <a:defRPr sz="4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2250" indent="-222250" algn="l" defTabSz="888365" rtl="0" eaLnBrk="1" latinLnBrk="0" hangingPunct="1">
        <a:lnSpc>
          <a:spcPct val="90000"/>
        </a:lnSpc>
        <a:spcBef>
          <a:spcPts val="97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66750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11250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555750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2000250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444750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888615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333115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777615" indent="-222250" algn="l" defTabSz="888365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445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890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335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780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2225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667000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110865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555365" algn="l" defTabSz="88836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5B4CFE-60B4-B044-3EF6-64BA57E760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graph with colored dots&#10;&#10;AI-generated content may be incorrect.">
            <a:extLst>
              <a:ext uri="{FF2B5EF4-FFF2-40B4-BE49-F238E27FC236}">
                <a16:creationId xmlns:a16="http://schemas.microsoft.com/office/drawing/2014/main" id="{DEDDCE2A-44F2-1123-6D48-F905D418A6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592" y="580557"/>
            <a:ext cx="3021227" cy="2405104"/>
          </a:xfrm>
          <a:prstGeom prst="rect">
            <a:avLst/>
          </a:prstGeom>
        </p:spPr>
      </p:pic>
      <p:pic>
        <p:nvPicPr>
          <p:cNvPr id="27" name="Picture 26" descr="A graph with different colored dots&#10;&#10;AI-generated content may be incorrect.">
            <a:extLst>
              <a:ext uri="{FF2B5EF4-FFF2-40B4-BE49-F238E27FC236}">
                <a16:creationId xmlns:a16="http://schemas.microsoft.com/office/drawing/2014/main" id="{5916EDFD-E0B1-112B-C764-E896557CCE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7261" y="580557"/>
            <a:ext cx="3021226" cy="240510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4CF4E3B-DC7A-A015-46CC-D2C2915946C8}"/>
              </a:ext>
            </a:extLst>
          </p:cNvPr>
          <p:cNvSpPr txBox="1"/>
          <p:nvPr/>
        </p:nvSpPr>
        <p:spPr>
          <a:xfrm>
            <a:off x="180155" y="303274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a</a:t>
            </a:r>
            <a:endParaRPr lang="en-JP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C8699BE-7A8F-7499-B70D-4A22AF6C3850}"/>
              </a:ext>
            </a:extLst>
          </p:cNvPr>
          <p:cNvSpPr txBox="1"/>
          <p:nvPr/>
        </p:nvSpPr>
        <p:spPr>
          <a:xfrm>
            <a:off x="180155" y="3356232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c</a:t>
            </a:r>
            <a:endParaRPr lang="en-JP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83DFC8-AA55-BA91-1838-204A4DC24BC2}"/>
              </a:ext>
            </a:extLst>
          </p:cNvPr>
          <p:cNvSpPr txBox="1"/>
          <p:nvPr/>
        </p:nvSpPr>
        <p:spPr>
          <a:xfrm>
            <a:off x="3662402" y="334336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b</a:t>
            </a:r>
            <a:endParaRPr lang="en-JP" b="1" dirty="0"/>
          </a:p>
        </p:txBody>
      </p:sp>
      <p:pic>
        <p:nvPicPr>
          <p:cNvPr id="29" name="Picture 28" descr="A graph with different colored dots&#10;&#10;AI-generated content may be incorrect.">
            <a:extLst>
              <a:ext uri="{FF2B5EF4-FFF2-40B4-BE49-F238E27FC236}">
                <a16:creationId xmlns:a16="http://schemas.microsoft.com/office/drawing/2014/main" id="{14BF51E2-AF2F-CF9B-E12E-D6DEE21EB5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57626" y="3400611"/>
            <a:ext cx="4609553" cy="3714824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79373EB-11CC-2438-763D-E4FEC7B006D4}"/>
              </a:ext>
            </a:extLst>
          </p:cNvPr>
          <p:cNvSpPr txBox="1"/>
          <p:nvPr/>
        </p:nvSpPr>
        <p:spPr>
          <a:xfrm>
            <a:off x="180155" y="7237681"/>
            <a:ext cx="649769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1. PCA plots showing the clustering patterns of samples within the rice plant (a) and suspension cell (b) experiments, and in the combined dataset (c).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ngus: rice blast fungus; Plant: rice plant experiment; Cell: suspension cell experiment.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25358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77F292-5428-2BCC-E649-CC424066793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81AF1DA-2190-F4EB-4C29-4DF5CB887B3A}"/>
              </a:ext>
            </a:extLst>
          </p:cNvPr>
          <p:cNvSpPr txBox="1"/>
          <p:nvPr/>
        </p:nvSpPr>
        <p:spPr>
          <a:xfrm>
            <a:off x="240797" y="5616099"/>
            <a:ext cx="649769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2. Venn diagram showing the distribution of OsRLCK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) and OsAP2/ERF (b) DEGs in the rice plant and suspension cell experiments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Upward arrows indicate upregulated DEGs; downward arrows indicate downregulated DEGs.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6BAC18F-B7DF-9F9C-CC61-60DC5D45024F}"/>
              </a:ext>
            </a:extLst>
          </p:cNvPr>
          <p:cNvSpPr txBox="1"/>
          <p:nvPr/>
        </p:nvSpPr>
        <p:spPr>
          <a:xfrm>
            <a:off x="240797" y="606351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a</a:t>
            </a:r>
            <a:endParaRPr lang="en-JP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FB3162-5F10-B077-9365-24ED600D789F}"/>
              </a:ext>
            </a:extLst>
          </p:cNvPr>
          <p:cNvSpPr txBox="1"/>
          <p:nvPr/>
        </p:nvSpPr>
        <p:spPr>
          <a:xfrm>
            <a:off x="240797" y="3350176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b</a:t>
            </a:r>
            <a:endParaRPr lang="en-JP" b="1" dirty="0"/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239AEC66-D948-06F6-7B80-D1AA26B79183}"/>
              </a:ext>
            </a:extLst>
          </p:cNvPr>
          <p:cNvGrpSpPr/>
          <p:nvPr/>
        </p:nvGrpSpPr>
        <p:grpSpPr>
          <a:xfrm>
            <a:off x="1015518" y="734983"/>
            <a:ext cx="3999866" cy="1921184"/>
            <a:chOff x="367900" y="738664"/>
            <a:chExt cx="3999866" cy="1921184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ABC0726-9688-8521-4AD0-0196869B9D7E}"/>
                </a:ext>
              </a:extLst>
            </p:cNvPr>
            <p:cNvGrpSpPr/>
            <p:nvPr/>
          </p:nvGrpSpPr>
          <p:grpSpPr>
            <a:xfrm>
              <a:off x="960305" y="738664"/>
              <a:ext cx="2677949" cy="1603417"/>
              <a:chOff x="1133990" y="5933418"/>
              <a:chExt cx="2677949" cy="1603417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B339ED7A-BEE9-9A19-D793-046436570875}"/>
                  </a:ext>
                </a:extLst>
              </p:cNvPr>
              <p:cNvGrpSpPr/>
              <p:nvPr/>
            </p:nvGrpSpPr>
            <p:grpSpPr>
              <a:xfrm>
                <a:off x="1506008" y="5933418"/>
                <a:ext cx="1881937" cy="1603417"/>
                <a:chOff x="4715613" y="1312471"/>
                <a:chExt cx="1881937" cy="1603417"/>
              </a:xfrm>
            </p:grpSpPr>
            <p:pic>
              <p:nvPicPr>
                <p:cNvPr id="37" name="Picture 36">
                  <a:extLst>
                    <a:ext uri="{FF2B5EF4-FFF2-40B4-BE49-F238E27FC236}">
                      <a16:creationId xmlns:a16="http://schemas.microsoft.com/office/drawing/2014/main" id="{85550FFF-53DC-8C63-F45E-D8EF5705A1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/>
                <a:stretch/>
              </p:blipFill>
              <p:spPr>
                <a:xfrm>
                  <a:off x="4715613" y="1505652"/>
                  <a:ext cx="1881937" cy="1410236"/>
                </a:xfrm>
                <a:prstGeom prst="rect">
                  <a:avLst/>
                </a:prstGeom>
              </p:spPr>
            </p:pic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44856A36-7A46-E498-DA5D-EF5FD42D72FC}"/>
                    </a:ext>
                  </a:extLst>
                </p:cNvPr>
                <p:cNvSpPr txBox="1"/>
                <p:nvPr/>
              </p:nvSpPr>
              <p:spPr>
                <a:xfrm>
                  <a:off x="4741108" y="1312471"/>
                  <a:ext cx="18309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LCK</a:t>
                  </a:r>
                  <a:r>
                    <a:rPr lang="en-US" sz="12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Gs distribution</a:t>
                  </a:r>
                </a:p>
              </p:txBody>
            </p:sp>
          </p:grp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B20218C3-F6D6-C33B-0AA1-93A3CD7E080C}"/>
                  </a:ext>
                </a:extLst>
              </p:cNvPr>
              <p:cNvGrpSpPr/>
              <p:nvPr/>
            </p:nvGrpSpPr>
            <p:grpSpPr>
              <a:xfrm>
                <a:off x="1133990" y="6577363"/>
                <a:ext cx="494930" cy="563869"/>
                <a:chOff x="79550" y="4822804"/>
                <a:chExt cx="494930" cy="563869"/>
              </a:xfrm>
            </p:grpSpPr>
            <p:sp>
              <p:nvSpPr>
                <p:cNvPr id="21" name="Arrow: Down 20">
                  <a:extLst>
                    <a:ext uri="{FF2B5EF4-FFF2-40B4-BE49-F238E27FC236}">
                      <a16:creationId xmlns:a16="http://schemas.microsoft.com/office/drawing/2014/main" id="{43BCD434-E6A8-9E2D-BC61-8235CD9335A3}"/>
                    </a:ext>
                  </a:extLst>
                </p:cNvPr>
                <p:cNvSpPr/>
                <p:nvPr/>
              </p:nvSpPr>
              <p:spPr>
                <a:xfrm>
                  <a:off x="79550" y="5126281"/>
                  <a:ext cx="183372" cy="260392"/>
                </a:xfrm>
                <a:prstGeom prst="downArrow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Arrow: Down 21">
                  <a:extLst>
                    <a:ext uri="{FF2B5EF4-FFF2-40B4-BE49-F238E27FC236}">
                      <a16:creationId xmlns:a16="http://schemas.microsoft.com/office/drawing/2014/main" id="{E591883C-F573-6BC9-797C-42F231758064}"/>
                    </a:ext>
                  </a:extLst>
                </p:cNvPr>
                <p:cNvSpPr/>
                <p:nvPr/>
              </p:nvSpPr>
              <p:spPr>
                <a:xfrm rot="10800000">
                  <a:off x="79551" y="4822804"/>
                  <a:ext cx="183372" cy="260392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78CAEDE3-E978-407E-932A-1033F951F85D}"/>
                    </a:ext>
                  </a:extLst>
                </p:cNvPr>
                <p:cNvSpPr txBox="1"/>
                <p:nvPr/>
              </p:nvSpPr>
              <p:spPr>
                <a:xfrm>
                  <a:off x="219896" y="4848418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EF9E25C4-0C91-82D2-E9B5-41CDBC6E53AE}"/>
                    </a:ext>
                  </a:extLst>
                </p:cNvPr>
                <p:cNvSpPr txBox="1"/>
                <p:nvPr/>
              </p:nvSpPr>
              <p:spPr>
                <a:xfrm>
                  <a:off x="258262" y="5107420"/>
                  <a:ext cx="2696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642B5416-F874-1F28-A1D2-BAF7549241F2}"/>
                  </a:ext>
                </a:extLst>
              </p:cNvPr>
              <p:cNvGrpSpPr/>
              <p:nvPr/>
            </p:nvGrpSpPr>
            <p:grpSpPr>
              <a:xfrm>
                <a:off x="3326080" y="6613220"/>
                <a:ext cx="485859" cy="563869"/>
                <a:chOff x="79550" y="4822804"/>
                <a:chExt cx="485859" cy="563869"/>
              </a:xfrm>
            </p:grpSpPr>
            <p:sp>
              <p:nvSpPr>
                <p:cNvPr id="15" name="Arrow: Down 14">
                  <a:extLst>
                    <a:ext uri="{FF2B5EF4-FFF2-40B4-BE49-F238E27FC236}">
                      <a16:creationId xmlns:a16="http://schemas.microsoft.com/office/drawing/2014/main" id="{282E3A64-C9FD-23DB-F09D-20B62A84945B}"/>
                    </a:ext>
                  </a:extLst>
                </p:cNvPr>
                <p:cNvSpPr/>
                <p:nvPr/>
              </p:nvSpPr>
              <p:spPr>
                <a:xfrm>
                  <a:off x="79550" y="5126281"/>
                  <a:ext cx="183372" cy="260392"/>
                </a:xfrm>
                <a:prstGeom prst="downArrow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Arrow: Down 16">
                  <a:extLst>
                    <a:ext uri="{FF2B5EF4-FFF2-40B4-BE49-F238E27FC236}">
                      <a16:creationId xmlns:a16="http://schemas.microsoft.com/office/drawing/2014/main" id="{0EAF985A-8472-C797-E4AA-93CC24E69452}"/>
                    </a:ext>
                  </a:extLst>
                </p:cNvPr>
                <p:cNvSpPr/>
                <p:nvPr/>
              </p:nvSpPr>
              <p:spPr>
                <a:xfrm rot="10800000">
                  <a:off x="79551" y="4822804"/>
                  <a:ext cx="183372" cy="260392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F02ECB3E-72F3-DB49-8430-7788CEA7A579}"/>
                    </a:ext>
                  </a:extLst>
                </p:cNvPr>
                <p:cNvSpPr txBox="1"/>
                <p:nvPr/>
              </p:nvSpPr>
              <p:spPr>
                <a:xfrm>
                  <a:off x="210825" y="4842943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2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FC452D93-EB6F-DFDD-3D84-186617E80218}"/>
                    </a:ext>
                  </a:extLst>
                </p:cNvPr>
                <p:cNvSpPr txBox="1"/>
                <p:nvPr/>
              </p:nvSpPr>
              <p:spPr>
                <a:xfrm>
                  <a:off x="249191" y="5101945"/>
                  <a:ext cx="2696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</p:grp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4212BFC1-0A95-0D07-0EFA-5FD1E3D7E760}"/>
                </a:ext>
              </a:extLst>
            </p:cNvPr>
            <p:cNvGrpSpPr/>
            <p:nvPr/>
          </p:nvGrpSpPr>
          <p:grpSpPr>
            <a:xfrm>
              <a:off x="367900" y="2194719"/>
              <a:ext cx="3999866" cy="465129"/>
              <a:chOff x="7102833" y="1902871"/>
              <a:chExt cx="3999866" cy="465129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AC18EA1A-26A3-D2A5-F137-F7CDE7FD90A3}"/>
                  </a:ext>
                </a:extLst>
              </p:cNvPr>
              <p:cNvSpPr txBox="1"/>
              <p:nvPr/>
            </p:nvSpPr>
            <p:spPr>
              <a:xfrm>
                <a:off x="7102833" y="1906335"/>
                <a:ext cx="155301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ice plant </a:t>
                </a:r>
              </a:p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Rice blast fungus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5DC9C80-49B7-1D06-0A41-73EA43BD9A06}"/>
                  </a:ext>
                </a:extLst>
              </p:cNvPr>
              <p:cNvSpPr txBox="1"/>
              <p:nvPr/>
            </p:nvSpPr>
            <p:spPr>
              <a:xfrm>
                <a:off x="9405668" y="1902871"/>
                <a:ext cx="169703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ice suspension cell </a:t>
                </a:r>
              </a:p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Chitin)</a:t>
                </a:r>
              </a:p>
            </p:txBody>
          </p:sp>
        </p:grp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A593427-2123-C2C7-6E95-249DF3BD74A4}"/>
              </a:ext>
            </a:extLst>
          </p:cNvPr>
          <p:cNvGrpSpPr/>
          <p:nvPr/>
        </p:nvGrpSpPr>
        <p:grpSpPr>
          <a:xfrm>
            <a:off x="1123641" y="3517456"/>
            <a:ext cx="3977468" cy="1789937"/>
            <a:chOff x="500079" y="3537939"/>
            <a:chExt cx="3977468" cy="1789937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E1D3214F-9D42-1556-273A-D992B54E22E4}"/>
                </a:ext>
              </a:extLst>
            </p:cNvPr>
            <p:cNvGrpSpPr/>
            <p:nvPr/>
          </p:nvGrpSpPr>
          <p:grpSpPr>
            <a:xfrm>
              <a:off x="1005533" y="3537939"/>
              <a:ext cx="2632721" cy="1466257"/>
              <a:chOff x="4387342" y="1505133"/>
              <a:chExt cx="2632721" cy="1466257"/>
            </a:xfrm>
          </p:grpSpPr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7BD9967D-2C14-9482-0AC0-BB7837DAE6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4846236" y="1784651"/>
                <a:ext cx="1674634" cy="1186739"/>
              </a:xfrm>
              <a:prstGeom prst="rect">
                <a:avLst/>
              </a:prstGeom>
            </p:spPr>
          </p:pic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425FF13-2E81-D353-3506-113F1E7158F6}"/>
                  </a:ext>
                </a:extLst>
              </p:cNvPr>
              <p:cNvSpPr txBox="1"/>
              <p:nvPr/>
            </p:nvSpPr>
            <p:spPr>
              <a:xfrm>
                <a:off x="4664671" y="1505133"/>
                <a:ext cx="206062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P2/ERF DEGs distribution</a:t>
                </a:r>
              </a:p>
            </p:txBody>
          </p: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AA7F51B7-2BF8-054B-0BD1-FA44E002A003}"/>
                  </a:ext>
                </a:extLst>
              </p:cNvPr>
              <p:cNvGrpSpPr/>
              <p:nvPr/>
            </p:nvGrpSpPr>
            <p:grpSpPr>
              <a:xfrm>
                <a:off x="4387342" y="2057813"/>
                <a:ext cx="491576" cy="586518"/>
                <a:chOff x="-115126" y="4778139"/>
                <a:chExt cx="491576" cy="586518"/>
              </a:xfrm>
            </p:grpSpPr>
            <p:sp>
              <p:nvSpPr>
                <p:cNvPr id="61" name="Arrow: Down 60">
                  <a:extLst>
                    <a:ext uri="{FF2B5EF4-FFF2-40B4-BE49-F238E27FC236}">
                      <a16:creationId xmlns:a16="http://schemas.microsoft.com/office/drawing/2014/main" id="{50EDE818-673A-A7EB-680A-95EBF7D6E9C9}"/>
                    </a:ext>
                  </a:extLst>
                </p:cNvPr>
                <p:cNvSpPr/>
                <p:nvPr/>
              </p:nvSpPr>
              <p:spPr>
                <a:xfrm>
                  <a:off x="-115126" y="5081616"/>
                  <a:ext cx="183372" cy="260392"/>
                </a:xfrm>
                <a:prstGeom prst="downArrow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" name="Arrow: Down 61">
                  <a:extLst>
                    <a:ext uri="{FF2B5EF4-FFF2-40B4-BE49-F238E27FC236}">
                      <a16:creationId xmlns:a16="http://schemas.microsoft.com/office/drawing/2014/main" id="{2DC2D0A4-455F-26E3-4B32-86D76AD91F88}"/>
                    </a:ext>
                  </a:extLst>
                </p:cNvPr>
                <p:cNvSpPr/>
                <p:nvPr/>
              </p:nvSpPr>
              <p:spPr>
                <a:xfrm rot="10800000">
                  <a:off x="-115125" y="4778139"/>
                  <a:ext cx="183372" cy="260392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19EE122C-AB14-4A96-3853-9681CBAA98EE}"/>
                    </a:ext>
                  </a:extLst>
                </p:cNvPr>
                <p:cNvSpPr txBox="1"/>
                <p:nvPr/>
              </p:nvSpPr>
              <p:spPr>
                <a:xfrm>
                  <a:off x="21866" y="4828656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55B5867D-9EDB-F5B3-9A0A-13797869843C}"/>
                    </a:ext>
                  </a:extLst>
                </p:cNvPr>
                <p:cNvSpPr txBox="1"/>
                <p:nvPr/>
              </p:nvSpPr>
              <p:spPr>
                <a:xfrm>
                  <a:off x="60231" y="5087658"/>
                  <a:ext cx="26962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693D0E6B-6BA9-EF1D-D284-5E5C99489D06}"/>
                  </a:ext>
                </a:extLst>
              </p:cNvPr>
              <p:cNvGrpSpPr/>
              <p:nvPr/>
            </p:nvGrpSpPr>
            <p:grpSpPr>
              <a:xfrm>
                <a:off x="6482107" y="2099096"/>
                <a:ext cx="537956" cy="563869"/>
                <a:chOff x="180666" y="4826649"/>
                <a:chExt cx="537956" cy="563869"/>
              </a:xfrm>
            </p:grpSpPr>
            <p:sp>
              <p:nvSpPr>
                <p:cNvPr id="57" name="Arrow: Down 56">
                  <a:extLst>
                    <a:ext uri="{FF2B5EF4-FFF2-40B4-BE49-F238E27FC236}">
                      <a16:creationId xmlns:a16="http://schemas.microsoft.com/office/drawing/2014/main" id="{5AF4E37F-1907-773E-E2C5-2752CED17CCB}"/>
                    </a:ext>
                  </a:extLst>
                </p:cNvPr>
                <p:cNvSpPr/>
                <p:nvPr/>
              </p:nvSpPr>
              <p:spPr>
                <a:xfrm>
                  <a:off x="180666" y="5130126"/>
                  <a:ext cx="183372" cy="260392"/>
                </a:xfrm>
                <a:prstGeom prst="downArrow">
                  <a:avLst/>
                </a:prstGeom>
                <a:solidFill>
                  <a:schemeClr val="accent5">
                    <a:lumMod val="60000"/>
                    <a:lumOff val="4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Arrow: Down 57">
                  <a:extLst>
                    <a:ext uri="{FF2B5EF4-FFF2-40B4-BE49-F238E27FC236}">
                      <a16:creationId xmlns:a16="http://schemas.microsoft.com/office/drawing/2014/main" id="{8755504B-580A-0939-C387-1655DB2B2613}"/>
                    </a:ext>
                  </a:extLst>
                </p:cNvPr>
                <p:cNvSpPr/>
                <p:nvPr/>
              </p:nvSpPr>
              <p:spPr>
                <a:xfrm rot="10800000">
                  <a:off x="180667" y="4826649"/>
                  <a:ext cx="183372" cy="260392"/>
                </a:xfrm>
                <a:prstGeom prst="downArrow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3D7FFFDE-02D7-438C-4563-D28E32BDC45A}"/>
                    </a:ext>
                  </a:extLst>
                </p:cNvPr>
                <p:cNvSpPr txBox="1"/>
                <p:nvPr/>
              </p:nvSpPr>
              <p:spPr>
                <a:xfrm>
                  <a:off x="364038" y="4835883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CC20500D-66F8-9788-8266-CF3EE0D66FC8}"/>
                    </a:ext>
                  </a:extLst>
                </p:cNvPr>
                <p:cNvSpPr txBox="1"/>
                <p:nvPr/>
              </p:nvSpPr>
              <p:spPr>
                <a:xfrm>
                  <a:off x="359924" y="5094885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1C22D20-28A0-4AE0-B124-65FCACAFC99C}"/>
                </a:ext>
              </a:extLst>
            </p:cNvPr>
            <p:cNvGrpSpPr/>
            <p:nvPr/>
          </p:nvGrpSpPr>
          <p:grpSpPr>
            <a:xfrm>
              <a:off x="500079" y="4862747"/>
              <a:ext cx="3977468" cy="465129"/>
              <a:chOff x="7102833" y="1902871"/>
              <a:chExt cx="3977468" cy="465129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4BDD0D5-C1AE-CD88-56E1-0D5899176B32}"/>
                  </a:ext>
                </a:extLst>
              </p:cNvPr>
              <p:cNvSpPr txBox="1"/>
              <p:nvPr/>
            </p:nvSpPr>
            <p:spPr>
              <a:xfrm>
                <a:off x="7102833" y="1906335"/>
                <a:ext cx="155301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ice plant </a:t>
                </a:r>
              </a:p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Rice blast fungus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FC9A21C-6FEB-6248-4A56-F13873B06439}"/>
                  </a:ext>
                </a:extLst>
              </p:cNvPr>
              <p:cNvSpPr txBox="1"/>
              <p:nvPr/>
            </p:nvSpPr>
            <p:spPr>
              <a:xfrm>
                <a:off x="9405668" y="1902871"/>
                <a:ext cx="167463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ice suspension cell </a:t>
                </a:r>
              </a:p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Chitin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38284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063CC4-1CE7-4B37-F808-A9C3CEA1F8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CC85F62-CBA0-7F4F-DF7F-AEFAE11950BC}"/>
              </a:ext>
            </a:extLst>
          </p:cNvPr>
          <p:cNvSpPr txBox="1"/>
          <p:nvPr/>
        </p:nvSpPr>
        <p:spPr>
          <a:xfrm>
            <a:off x="180155" y="8072862"/>
            <a:ext cx="649769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3. Identification of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OsRLCK298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X lines,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rf65,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rf96.2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KO lines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a) The transcript levels of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OsRLCK298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n OX lines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pared with the wild type (WT) were confirmed before the punch infection assay. (b) cDNA sequence alignments for WT, and the mutant T2 homozygous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erf65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and erf96.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ines. Untranslated regions, exons, and introns are indicated by blank rectangles, black rectangles, and black lines, respectively. 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495E626-A9A8-ACF3-4F97-26723D3C5A8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434302" y="337218"/>
            <a:ext cx="2860727" cy="386533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AE292E3-53AA-3C0E-F8BC-6B68F5ECC7C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3458055" y="256941"/>
            <a:ext cx="2188929" cy="39281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4D9CCDB-A8D3-4AEA-BC5A-CB215F091F5A}"/>
              </a:ext>
            </a:extLst>
          </p:cNvPr>
          <p:cNvSpPr txBox="1"/>
          <p:nvPr/>
        </p:nvSpPr>
        <p:spPr>
          <a:xfrm>
            <a:off x="240797" y="278188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a</a:t>
            </a:r>
            <a:endParaRPr lang="en-JP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0F2E9C-EA76-38EF-2C4F-2764741D1D28}"/>
              </a:ext>
            </a:extLst>
          </p:cNvPr>
          <p:cNvSpPr txBox="1"/>
          <p:nvPr/>
        </p:nvSpPr>
        <p:spPr>
          <a:xfrm>
            <a:off x="227881" y="4699753"/>
            <a:ext cx="518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b</a:t>
            </a:r>
            <a:endParaRPr lang="en-JP" b="1" dirty="0"/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47ABBB4F-63C0-F29D-FE6E-95489FF09E99}"/>
              </a:ext>
            </a:extLst>
          </p:cNvPr>
          <p:cNvGrpSpPr/>
          <p:nvPr/>
        </p:nvGrpSpPr>
        <p:grpSpPr>
          <a:xfrm>
            <a:off x="1047171" y="4635698"/>
            <a:ext cx="4599814" cy="1348857"/>
            <a:chOff x="1047171" y="4604013"/>
            <a:chExt cx="4599814" cy="1348857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CC8F005C-0AC9-EB67-C8BE-FEBAB357AC73}"/>
                </a:ext>
              </a:extLst>
            </p:cNvPr>
            <p:cNvGrpSpPr/>
            <p:nvPr/>
          </p:nvGrpSpPr>
          <p:grpSpPr>
            <a:xfrm>
              <a:off x="1047171" y="5122517"/>
              <a:ext cx="4599814" cy="830353"/>
              <a:chOff x="475388" y="5953051"/>
              <a:chExt cx="4599814" cy="830353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3C2C1B75-6BCE-D4FA-03ED-7BB9C954F602}"/>
                  </a:ext>
                </a:extLst>
              </p:cNvPr>
              <p:cNvGrpSpPr/>
              <p:nvPr/>
            </p:nvGrpSpPr>
            <p:grpSpPr>
              <a:xfrm>
                <a:off x="475388" y="5953051"/>
                <a:ext cx="3483479" cy="830353"/>
                <a:chOff x="781095" y="6011986"/>
                <a:chExt cx="3483479" cy="830353"/>
              </a:xfrm>
            </p:grpSpPr>
            <p:sp>
              <p:nvSpPr>
                <p:cNvPr id="24" name="Text Placeholder 2">
                  <a:extLst>
                    <a:ext uri="{FF2B5EF4-FFF2-40B4-BE49-F238E27FC236}">
                      <a16:creationId xmlns:a16="http://schemas.microsoft.com/office/drawing/2014/main" id="{4A8F991B-20C7-E402-C983-58930A1ED55A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1146507" y="6011986"/>
                  <a:ext cx="2992399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AGAGGAAGACGCGATACCGAGGG </a:t>
                  </a:r>
                </a:p>
              </p:txBody>
            </p:sp>
            <p:sp>
              <p:nvSpPr>
                <p:cNvPr id="25" name="Text Placeholder 2">
                  <a:extLst>
                    <a:ext uri="{FF2B5EF4-FFF2-40B4-BE49-F238E27FC236}">
                      <a16:creationId xmlns:a16="http://schemas.microsoft.com/office/drawing/2014/main" id="{644F81FC-451D-9923-62C2-002EB060759F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805786" y="6290519"/>
                  <a:ext cx="3458788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f65_1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AGAGGAAGACGCGATAC</a:t>
                  </a:r>
                  <a:r>
                    <a:rPr lang="en-US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AGGG </a:t>
                  </a:r>
                </a:p>
              </p:txBody>
            </p:sp>
            <p:sp>
              <p:nvSpPr>
                <p:cNvPr id="26" name="Text Placeholder 2">
                  <a:extLst>
                    <a:ext uri="{FF2B5EF4-FFF2-40B4-BE49-F238E27FC236}">
                      <a16:creationId xmlns:a16="http://schemas.microsoft.com/office/drawing/2014/main" id="{F5DD7C94-0D6B-7784-FF83-9B4A9A6D93F3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81095" y="6563806"/>
                  <a:ext cx="3303201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f65_4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AGAGGAAGACGCGATAC</a:t>
                  </a:r>
                  <a:r>
                    <a:rPr lang="en-US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GGG</a:t>
                  </a:r>
                </a:p>
              </p:txBody>
            </p:sp>
          </p:grpSp>
          <p:sp>
            <p:nvSpPr>
              <p:cNvPr id="27" name="Text Placeholder 2">
                <a:extLst>
                  <a:ext uri="{FF2B5EF4-FFF2-40B4-BE49-F238E27FC236}">
                    <a16:creationId xmlns:a16="http://schemas.microsoft.com/office/drawing/2014/main" id="{537A06A8-D5C7-6DEE-B6E1-791CED4680F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114204" y="6231584"/>
                <a:ext cx="909523" cy="278533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None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1bp, +G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 Placeholder 2">
                <a:extLst>
                  <a:ext uri="{FF2B5EF4-FFF2-40B4-BE49-F238E27FC236}">
                    <a16:creationId xmlns:a16="http://schemas.microsoft.com/office/drawing/2014/main" id="{07E61911-0939-0227-A167-5D54D6E1BA6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165679" y="6470024"/>
                <a:ext cx="909523" cy="278533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None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bp, -C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1" name="Picture 20" descr="A graph of dna sequence&#10;&#10;AI-generated content may be incorrect.">
              <a:extLst>
                <a:ext uri="{FF2B5EF4-FFF2-40B4-BE49-F238E27FC236}">
                  <a16:creationId xmlns:a16="http://schemas.microsoft.com/office/drawing/2014/main" id="{4EA6DF19-6FF5-C32A-6230-5E62942E65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b="62804"/>
            <a:stretch>
              <a:fillRect/>
            </a:stretch>
          </p:blipFill>
          <p:spPr>
            <a:xfrm>
              <a:off x="1071862" y="4604013"/>
              <a:ext cx="3298345" cy="519532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0BD0FAD-8067-3C9E-7AB8-FCEC060CB9D4}"/>
              </a:ext>
            </a:extLst>
          </p:cNvPr>
          <p:cNvGrpSpPr/>
          <p:nvPr/>
        </p:nvGrpSpPr>
        <p:grpSpPr>
          <a:xfrm>
            <a:off x="877462" y="6407728"/>
            <a:ext cx="4718048" cy="1386601"/>
            <a:chOff x="877462" y="6407728"/>
            <a:chExt cx="4718048" cy="1386601"/>
          </a:xfrm>
        </p:grpSpPr>
        <p:pic>
          <p:nvPicPr>
            <p:cNvPr id="6" name="Picture 5" descr="A black and grey rectangular object with letters&#10;&#10;AI-generated content may be incorrect.">
              <a:extLst>
                <a:ext uri="{FF2B5EF4-FFF2-40B4-BE49-F238E27FC236}">
                  <a16:creationId xmlns:a16="http://schemas.microsoft.com/office/drawing/2014/main" id="{A49A695C-A12E-FDB8-8D36-58E73887A3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32372" y="6407728"/>
              <a:ext cx="1984857" cy="519413"/>
            </a:xfrm>
            <a:prstGeom prst="rect">
              <a:avLst/>
            </a:prstGeom>
          </p:spPr>
        </p:pic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68EBCFC8-895E-CC1B-9645-27110503B0BA}"/>
                </a:ext>
              </a:extLst>
            </p:cNvPr>
            <p:cNvGrpSpPr/>
            <p:nvPr/>
          </p:nvGrpSpPr>
          <p:grpSpPr>
            <a:xfrm>
              <a:off x="877462" y="6940722"/>
              <a:ext cx="4718048" cy="853607"/>
              <a:chOff x="327489" y="7072770"/>
              <a:chExt cx="4718048" cy="853607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2A10E8DD-E396-7611-93D3-DE42BFBB5482}"/>
                  </a:ext>
                </a:extLst>
              </p:cNvPr>
              <p:cNvGrpSpPr/>
              <p:nvPr/>
            </p:nvGrpSpPr>
            <p:grpSpPr>
              <a:xfrm>
                <a:off x="327489" y="7072770"/>
                <a:ext cx="3631378" cy="853607"/>
                <a:chOff x="684671" y="6006976"/>
                <a:chExt cx="3631378" cy="853607"/>
              </a:xfrm>
            </p:grpSpPr>
            <p:sp>
              <p:nvSpPr>
                <p:cNvPr id="7" name="Text Placeholder 2">
                  <a:extLst>
                    <a:ext uri="{FF2B5EF4-FFF2-40B4-BE49-F238E27FC236}">
                      <a16:creationId xmlns:a16="http://schemas.microsoft.com/office/drawing/2014/main" id="{0C40B327-A687-A76A-E7B6-E9240A8027AD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1149755" y="6006976"/>
                  <a:ext cx="3062436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GAGTGCTTCGAGCTCGGCGGCGG </a:t>
                  </a:r>
                </a:p>
              </p:txBody>
            </p:sp>
            <p:sp>
              <p:nvSpPr>
                <p:cNvPr id="8" name="Text Placeholder 2">
                  <a:extLst>
                    <a:ext uri="{FF2B5EF4-FFF2-40B4-BE49-F238E27FC236}">
                      <a16:creationId xmlns:a16="http://schemas.microsoft.com/office/drawing/2014/main" id="{680F9706-5528-BAF8-8BB2-478A324278E0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684671" y="6293487"/>
                  <a:ext cx="3631378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f96.2_3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GAGTGCTTCGAGCTCGG</a:t>
                  </a:r>
                  <a:r>
                    <a:rPr lang="en-US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GCGG </a:t>
                  </a:r>
                </a:p>
              </p:txBody>
            </p:sp>
            <p:sp>
              <p:nvSpPr>
                <p:cNvPr id="9" name="Text Placeholder 2">
                  <a:extLst>
                    <a:ext uri="{FF2B5EF4-FFF2-40B4-BE49-F238E27FC236}">
                      <a16:creationId xmlns:a16="http://schemas.microsoft.com/office/drawing/2014/main" id="{5EC8A69B-C849-1060-C2FC-C84608E921B3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36600" y="6582050"/>
                  <a:ext cx="3527520" cy="278533"/>
                </a:xfrm>
                <a:prstGeom prst="rect">
                  <a:avLst/>
                </a:prstGeom>
                <a:ln>
                  <a:noFill/>
                </a:ln>
              </p:spPr>
              <p:txBody>
                <a:bodyPr vert="horz" lIns="91440" tIns="45720" rIns="91440" bIns="45720" rtlCol="0">
                  <a:noAutofit/>
                </a:bodyPr>
                <a:lstStyle>
                  <a:lvl1pPr marL="228600" indent="-228600" algn="l" defTabSz="914400" rtl="0" eaLnBrk="1" latinLnBrk="0" hangingPunct="1"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685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1143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600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20574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5146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9718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4290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886200" indent="-228600" algn="l" defTabSz="914400" rtl="0" eaLnBrk="1" latinLnBrk="0" hangingPunct="1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marL="0" indent="0" algn="ctr">
                    <a:buNone/>
                  </a:pPr>
                  <a:r>
                    <a:rPr lang="en-US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f96.2_8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:GAGTGCTTCGAGCTCGG</a:t>
                  </a:r>
                  <a:r>
                    <a:rPr lang="en-US" sz="12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GGCGG</a:t>
                  </a:r>
                </a:p>
              </p:txBody>
            </p:sp>
          </p:grpSp>
          <p:sp>
            <p:nvSpPr>
              <p:cNvPr id="29" name="Text Placeholder 2">
                <a:extLst>
                  <a:ext uri="{FF2B5EF4-FFF2-40B4-BE49-F238E27FC236}">
                    <a16:creationId xmlns:a16="http://schemas.microsoft.com/office/drawing/2014/main" id="{5E8EA5F1-A964-DFF8-208B-2F11335F5A9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136014" y="7351303"/>
                <a:ext cx="909523" cy="278533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None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1bp, +G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 Placeholder 2">
                <a:extLst>
                  <a:ext uri="{FF2B5EF4-FFF2-40B4-BE49-F238E27FC236}">
                    <a16:creationId xmlns:a16="http://schemas.microsoft.com/office/drawing/2014/main" id="{F8812580-2F24-5B09-F8E3-88431902018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136014" y="7589743"/>
                <a:ext cx="909523" cy="278533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None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1bp, +T</a:t>
                </a:r>
                <a:endParaRPr 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484327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CD955B-D3DF-0485-8262-A0A999B5D3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olorful explosion of light&#10;&#10;AI-generated content may be incorrect.">
            <a:extLst>
              <a:ext uri="{FF2B5EF4-FFF2-40B4-BE49-F238E27FC236}">
                <a16:creationId xmlns:a16="http://schemas.microsoft.com/office/drawing/2014/main" id="{28405FD7-E8BC-03DB-6834-AFED4115E00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87" r="36538"/>
          <a:stretch>
            <a:fillRect/>
          </a:stretch>
        </p:blipFill>
        <p:spPr>
          <a:xfrm>
            <a:off x="53761" y="664229"/>
            <a:ext cx="6713862" cy="545455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51789EE-AB84-0763-26F3-576CEF0DC1E7}"/>
              </a:ext>
            </a:extLst>
          </p:cNvPr>
          <p:cNvSpPr txBox="1"/>
          <p:nvPr/>
        </p:nvSpPr>
        <p:spPr>
          <a:xfrm>
            <a:off x="180155" y="7423600"/>
            <a:ext cx="649769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4. Phylogenetic tree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sRLK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by subfamily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red branches denote the RLK-LRR-XII subfamily, which is well-known for MAMP perception. 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83400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ircular object with different colored circles&#10;&#10;AI-generated content may be incorrect.">
            <a:extLst>
              <a:ext uri="{FF2B5EF4-FFF2-40B4-BE49-F238E27FC236}">
                <a16:creationId xmlns:a16="http://schemas.microsoft.com/office/drawing/2014/main" id="{F678DF6C-70B4-73FA-833E-35F89382DCF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92" r="42963"/>
          <a:stretch>
            <a:fillRect/>
          </a:stretch>
        </p:blipFill>
        <p:spPr>
          <a:xfrm>
            <a:off x="31293" y="294217"/>
            <a:ext cx="6826707" cy="6197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DA9093-6F28-831F-4A07-BB6D8F0C81FD}"/>
              </a:ext>
            </a:extLst>
          </p:cNvPr>
          <p:cNvSpPr txBox="1"/>
          <p:nvPr/>
        </p:nvSpPr>
        <p:spPr>
          <a:xfrm>
            <a:off x="247889" y="6576933"/>
            <a:ext cx="649769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5. DEG distribution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sRLK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across different subfamilies.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OsRLK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EGs in the rice plant and suspension cell experiments are denoted with green and blue dots, respectively. The red branches denote the RLK-LRR-XII subfamily, which is well-known for MAMP perception. </a:t>
            </a:r>
            <a:endParaRPr lang="en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60438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1C38F4-05F3-C2F4-1B3B-20C66831AC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fireworks in the dark&#10;&#10;AI-generated content may be incorrect.">
            <a:extLst>
              <a:ext uri="{FF2B5EF4-FFF2-40B4-BE49-F238E27FC236}">
                <a16:creationId xmlns:a16="http://schemas.microsoft.com/office/drawing/2014/main" id="{CB37DB46-FA58-24BA-9216-3FCFE0CE92A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91" r="46800"/>
          <a:stretch>
            <a:fillRect/>
          </a:stretch>
        </p:blipFill>
        <p:spPr>
          <a:xfrm>
            <a:off x="0" y="858192"/>
            <a:ext cx="6858000" cy="664293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1D9F4BA-28F3-A121-3A1D-1F79889E04C5}"/>
              </a:ext>
            </a:extLst>
          </p:cNvPr>
          <p:cNvSpPr txBox="1"/>
          <p:nvPr/>
        </p:nvSpPr>
        <p:spPr>
          <a:xfrm>
            <a:off x="173322" y="7849151"/>
            <a:ext cx="649769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. S6. Phylogenetic tree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sRLPs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y subfamily and DEG distribution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sRLPs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ross different subfamilies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OsRL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EGs in the rice plant and suspension cell experiments are denoted with green and blue dots, respectively. </a:t>
            </a:r>
            <a:endParaRPr lang="en-JP" sz="1400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100275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83</TotalTime>
  <Words>425</Words>
  <Application>Microsoft Office PowerPoint</Application>
  <PresentationFormat>A4 Paper (210x297 mm)</PresentationFormat>
  <Paragraphs>54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1_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ina</dc:creator>
  <cp:lastModifiedBy>Wanqing Wang</cp:lastModifiedBy>
  <cp:revision>855</cp:revision>
  <cp:lastPrinted>2025-03-31T05:29:45Z</cp:lastPrinted>
  <dcterms:created xsi:type="dcterms:W3CDTF">2016-12-28T07:56:00Z</dcterms:created>
  <dcterms:modified xsi:type="dcterms:W3CDTF">2026-03-03T02:1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60</vt:lpwstr>
  </property>
</Properties>
</file>